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6" r:id="rId2"/>
    <p:sldId id="257" r:id="rId3"/>
    <p:sldId id="312" r:id="rId4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7161CB1-0C7C-4227-B6DF-939EB801456D}" v="19" dt="2024-03-07T21:23:44.2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>
        <p:scale>
          <a:sx n="93" d="100"/>
          <a:sy n="93" d="100"/>
        </p:scale>
        <p:origin x="139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ONDO YUSUKE" userId="a477efb4f86a0ef6" providerId="LiveId" clId="{27161CB1-0C7C-4227-B6DF-939EB801456D}"/>
    <pc:docChg chg="undo custSel addSld delSld modSld sldOrd">
      <pc:chgData name="KONDO YUSUKE" userId="a477efb4f86a0ef6" providerId="LiveId" clId="{27161CB1-0C7C-4227-B6DF-939EB801456D}" dt="2024-03-07T21:32:02.437" v="55" actId="20577"/>
      <pc:docMkLst>
        <pc:docMk/>
      </pc:docMkLst>
      <pc:sldChg chg="del">
        <pc:chgData name="KONDO YUSUKE" userId="a477efb4f86a0ef6" providerId="LiveId" clId="{27161CB1-0C7C-4227-B6DF-939EB801456D}" dt="2024-03-07T21:14:41.311" v="4" actId="47"/>
        <pc:sldMkLst>
          <pc:docMk/>
          <pc:sldMk cId="4014746037" sldId="256"/>
        </pc:sldMkLst>
      </pc:sldChg>
      <pc:sldChg chg="modSp mod">
        <pc:chgData name="KONDO YUSUKE" userId="a477efb4f86a0ef6" providerId="LiveId" clId="{27161CB1-0C7C-4227-B6DF-939EB801456D}" dt="2024-03-07T21:32:02.437" v="55" actId="20577"/>
        <pc:sldMkLst>
          <pc:docMk/>
          <pc:sldMk cId="2809458237" sldId="257"/>
        </pc:sldMkLst>
        <pc:spChg chg="mod">
          <ac:chgData name="KONDO YUSUKE" userId="a477efb4f86a0ef6" providerId="LiveId" clId="{27161CB1-0C7C-4227-B6DF-939EB801456D}" dt="2024-03-07T21:32:02.437" v="55" actId="20577"/>
          <ac:spMkLst>
            <pc:docMk/>
            <pc:sldMk cId="2809458237" sldId="257"/>
            <ac:spMk id="6" creationId="{18970258-7E4F-4265-A0BD-09CC6CC2B69D}"/>
          </ac:spMkLst>
        </pc:spChg>
      </pc:sldChg>
      <pc:sldChg chg="del">
        <pc:chgData name="KONDO YUSUKE" userId="a477efb4f86a0ef6" providerId="LiveId" clId="{27161CB1-0C7C-4227-B6DF-939EB801456D}" dt="2024-03-07T21:14:38.150" v="2" actId="47"/>
        <pc:sldMkLst>
          <pc:docMk/>
          <pc:sldMk cId="4227890905" sldId="267"/>
        </pc:sldMkLst>
      </pc:sldChg>
      <pc:sldChg chg="del">
        <pc:chgData name="KONDO YUSUKE" userId="a477efb4f86a0ef6" providerId="LiveId" clId="{27161CB1-0C7C-4227-B6DF-939EB801456D}" dt="2024-03-07T21:14:41.758" v="5" actId="47"/>
        <pc:sldMkLst>
          <pc:docMk/>
          <pc:sldMk cId="3360476881" sldId="276"/>
        </pc:sldMkLst>
      </pc:sldChg>
      <pc:sldChg chg="del">
        <pc:chgData name="KONDO YUSUKE" userId="a477efb4f86a0ef6" providerId="LiveId" clId="{27161CB1-0C7C-4227-B6DF-939EB801456D}" dt="2024-03-07T21:14:35.764" v="1" actId="47"/>
        <pc:sldMkLst>
          <pc:docMk/>
          <pc:sldMk cId="2269027711" sldId="293"/>
        </pc:sldMkLst>
      </pc:sldChg>
      <pc:sldChg chg="del">
        <pc:chgData name="KONDO YUSUKE" userId="a477efb4f86a0ef6" providerId="LiveId" clId="{27161CB1-0C7C-4227-B6DF-939EB801456D}" dt="2024-03-07T21:14:34.390" v="0" actId="47"/>
        <pc:sldMkLst>
          <pc:docMk/>
          <pc:sldMk cId="409323522" sldId="294"/>
        </pc:sldMkLst>
      </pc:sldChg>
      <pc:sldChg chg="modSp mod">
        <pc:chgData name="KONDO YUSUKE" userId="a477efb4f86a0ef6" providerId="LiveId" clId="{27161CB1-0C7C-4227-B6DF-939EB801456D}" dt="2024-03-07T21:23:44.217" v="49"/>
        <pc:sldMkLst>
          <pc:docMk/>
          <pc:sldMk cId="546144196" sldId="312"/>
        </pc:sldMkLst>
        <pc:spChg chg="mod">
          <ac:chgData name="KONDO YUSUKE" userId="a477efb4f86a0ef6" providerId="LiveId" clId="{27161CB1-0C7C-4227-B6DF-939EB801456D}" dt="2024-03-07T21:15:17.935" v="23" actId="20577"/>
          <ac:spMkLst>
            <pc:docMk/>
            <pc:sldMk cId="546144196" sldId="312"/>
            <ac:spMk id="23" creationId="{C17C71EB-FA51-4764-816C-DA855D88DA9E}"/>
          </ac:spMkLst>
        </pc:spChg>
        <pc:graphicFrameChg chg="mod">
          <ac:chgData name="KONDO YUSUKE" userId="a477efb4f86a0ef6" providerId="LiveId" clId="{27161CB1-0C7C-4227-B6DF-939EB801456D}" dt="2024-03-07T21:23:44.217" v="49"/>
          <ac:graphicFrameMkLst>
            <pc:docMk/>
            <pc:sldMk cId="546144196" sldId="312"/>
            <ac:graphicFrameMk id="7" creationId="{74190B27-E23B-4A11-995B-A0179897E528}"/>
          </ac:graphicFrameMkLst>
        </pc:graphicFrameChg>
      </pc:sldChg>
      <pc:sldChg chg="add del">
        <pc:chgData name="KONDO YUSUKE" userId="a477efb4f86a0ef6" providerId="LiveId" clId="{27161CB1-0C7C-4227-B6DF-939EB801456D}" dt="2024-03-07T21:15:13.657" v="21" actId="47"/>
        <pc:sldMkLst>
          <pc:docMk/>
          <pc:sldMk cId="632202111" sldId="313"/>
        </pc:sldMkLst>
      </pc:sldChg>
      <pc:sldChg chg="add del">
        <pc:chgData name="KONDO YUSUKE" userId="a477efb4f86a0ef6" providerId="LiveId" clId="{27161CB1-0C7C-4227-B6DF-939EB801456D}" dt="2024-03-07T21:15:11.873" v="19" actId="47"/>
        <pc:sldMkLst>
          <pc:docMk/>
          <pc:sldMk cId="3284228009" sldId="314"/>
        </pc:sldMkLst>
      </pc:sldChg>
      <pc:sldChg chg="add del">
        <pc:chgData name="KONDO YUSUKE" userId="a477efb4f86a0ef6" providerId="LiveId" clId="{27161CB1-0C7C-4227-B6DF-939EB801456D}" dt="2024-03-07T21:15:11.020" v="18" actId="47"/>
        <pc:sldMkLst>
          <pc:docMk/>
          <pc:sldMk cId="3249149522" sldId="315"/>
        </pc:sldMkLst>
      </pc:sldChg>
      <pc:sldChg chg="modSp del mod ord">
        <pc:chgData name="KONDO YUSUKE" userId="a477efb4f86a0ef6" providerId="LiveId" clId="{27161CB1-0C7C-4227-B6DF-939EB801456D}" dt="2024-03-07T21:31:57.781" v="53" actId="20577"/>
        <pc:sldMkLst>
          <pc:docMk/>
          <pc:sldMk cId="139467487" sldId="316"/>
        </pc:sldMkLst>
        <pc:spChg chg="mod">
          <ac:chgData name="KONDO YUSUKE" userId="a477efb4f86a0ef6" providerId="LiveId" clId="{27161CB1-0C7C-4227-B6DF-939EB801456D}" dt="2024-03-07T21:31:57.781" v="53" actId="20577"/>
          <ac:spMkLst>
            <pc:docMk/>
            <pc:sldMk cId="139467487" sldId="316"/>
            <ac:spMk id="6" creationId="{E76FA3C3-017C-46BF-BCC9-4530E0A1125E}"/>
          </ac:spMkLst>
        </pc:spChg>
        <pc:graphicFrameChg chg="mod">
          <ac:chgData name="KONDO YUSUKE" userId="a477efb4f86a0ef6" providerId="LiveId" clId="{27161CB1-0C7C-4227-B6DF-939EB801456D}" dt="2024-03-07T21:23:07.397" v="46" actId="255"/>
          <ac:graphicFrameMkLst>
            <pc:docMk/>
            <pc:sldMk cId="139467487" sldId="316"/>
            <ac:graphicFrameMk id="9" creationId="{79CEAADC-81BA-49EF-9B38-13369C8E95ED}"/>
          </ac:graphicFrameMkLst>
        </pc:graphicFrameChg>
      </pc:sldChg>
      <pc:sldChg chg="add del">
        <pc:chgData name="KONDO YUSUKE" userId="a477efb4f86a0ef6" providerId="LiveId" clId="{27161CB1-0C7C-4227-B6DF-939EB801456D}" dt="2024-03-07T21:15:12.469" v="20" actId="47"/>
        <pc:sldMkLst>
          <pc:docMk/>
          <pc:sldMk cId="325566708" sldId="317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81907\OneDrive\&#12487;&#12473;&#12463;&#12488;&#12483;&#12503;\CRTD&#12398;&#29366;&#27841;&#12288;QRS&#24133;&#29992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01e49d921f4798ed/&#12487;&#12473;&#12463;&#12488;&#12483;&#12503;/CRTD&#12398;&#29366;&#27841;&#12288;QRS&#24133;&#29992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81907\OneDrive\&#12487;&#12473;&#12463;&#12488;&#12483;&#12503;\CRTD&#12398;&#29366;&#27841;&#12288;QRS&#24133;&#2999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2000"/>
            </a:pPr>
            <a:r>
              <a:rPr lang="en-US" altLang="ja-JP" sz="2000" dirty="0"/>
              <a:t>Appropriate ICD</a:t>
            </a:r>
            <a:r>
              <a:rPr lang="en-US" altLang="ja-JP" sz="2000" baseline="0" dirty="0"/>
              <a:t> therapy</a:t>
            </a:r>
            <a:endParaRPr lang="ja-JP" altLang="en-US" sz="2000" dirty="0"/>
          </a:p>
        </c:rich>
      </c:tx>
      <c:layout>
        <c:manualLayout>
          <c:xMode val="edge"/>
          <c:yMode val="edge"/>
          <c:x val="0.32622375678320437"/>
          <c:y val="1.880227996150714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9.2913775464816301E-2"/>
          <c:y val="0.12818454363757495"/>
          <c:w val="0.71836825015568007"/>
          <c:h val="0.74187190021467175"/>
        </c:manualLayout>
      </c:layout>
      <c:scatterChart>
        <c:scatterStyle val="lineMarker"/>
        <c:varyColors val="0"/>
        <c:ser>
          <c:idx val="0"/>
          <c:order val="0"/>
          <c:tx>
            <c:strRef>
              <c:f>作動月3群!$B$179</c:f>
              <c:strCache>
                <c:ptCount val="1"/>
                <c:pt idx="0">
                  <c:v>Class I</c:v>
                </c:pt>
              </c:strCache>
            </c:strRef>
          </c:tx>
          <c:spPr>
            <a:ln w="25400">
              <a:solidFill>
                <a:srgbClr val="4F81BD"/>
              </a:solidFill>
              <a:prstDash val="solid"/>
            </a:ln>
          </c:spPr>
          <c:marker>
            <c:symbol val="none"/>
          </c:marker>
          <c:xVal>
            <c:numRef>
              <c:f>作動月3群!$A$180:$A$245</c:f>
              <c:numCache>
                <c:formatCode>General</c:formatCode>
                <c:ptCount val="66"/>
                <c:pt idx="0">
                  <c:v>0</c:v>
                </c:pt>
                <c:pt idx="1">
                  <c:v>1.1666666666666667</c:v>
                </c:pt>
                <c:pt idx="2">
                  <c:v>8.9333333333333336</c:v>
                </c:pt>
                <c:pt idx="3">
                  <c:v>8.9333333333333336</c:v>
                </c:pt>
                <c:pt idx="4">
                  <c:v>9.6333333333333329</c:v>
                </c:pt>
                <c:pt idx="5">
                  <c:v>10.333333333333334</c:v>
                </c:pt>
                <c:pt idx="6">
                  <c:v>13.466666666666667</c:v>
                </c:pt>
                <c:pt idx="7">
                  <c:v>15.933333333333334</c:v>
                </c:pt>
                <c:pt idx="8">
                  <c:v>16.366666666666667</c:v>
                </c:pt>
                <c:pt idx="9">
                  <c:v>16.366666666666667</c:v>
                </c:pt>
                <c:pt idx="10">
                  <c:v>18.899999999999999</c:v>
                </c:pt>
                <c:pt idx="11">
                  <c:v>19.333333333333332</c:v>
                </c:pt>
                <c:pt idx="12">
                  <c:v>21.433333333333334</c:v>
                </c:pt>
                <c:pt idx="13">
                  <c:v>22.6</c:v>
                </c:pt>
                <c:pt idx="14">
                  <c:v>23.5</c:v>
                </c:pt>
                <c:pt idx="15">
                  <c:v>24.633333333333333</c:v>
                </c:pt>
                <c:pt idx="16">
                  <c:v>25.166666666666668</c:v>
                </c:pt>
                <c:pt idx="17">
                  <c:v>27.233333333333334</c:v>
                </c:pt>
                <c:pt idx="18">
                  <c:v>27.233333333333334</c:v>
                </c:pt>
                <c:pt idx="19">
                  <c:v>29.666666666666668</c:v>
                </c:pt>
                <c:pt idx="20">
                  <c:v>30.533333333333335</c:v>
                </c:pt>
                <c:pt idx="21">
                  <c:v>36.533333333333331</c:v>
                </c:pt>
                <c:pt idx="22">
                  <c:v>36.833333333333336</c:v>
                </c:pt>
                <c:pt idx="23">
                  <c:v>36.866666666666667</c:v>
                </c:pt>
                <c:pt idx="24">
                  <c:v>37.06666666666667</c:v>
                </c:pt>
                <c:pt idx="25">
                  <c:v>42</c:v>
                </c:pt>
                <c:pt idx="26">
                  <c:v>42</c:v>
                </c:pt>
                <c:pt idx="27">
                  <c:v>42.033333333333331</c:v>
                </c:pt>
                <c:pt idx="28">
                  <c:v>42.5</c:v>
                </c:pt>
                <c:pt idx="29">
                  <c:v>45.466666666666669</c:v>
                </c:pt>
                <c:pt idx="30">
                  <c:v>46.233333333333334</c:v>
                </c:pt>
                <c:pt idx="31">
                  <c:v>46.3</c:v>
                </c:pt>
                <c:pt idx="32">
                  <c:v>49.666666666666664</c:v>
                </c:pt>
                <c:pt idx="33">
                  <c:v>49.9</c:v>
                </c:pt>
                <c:pt idx="34">
                  <c:v>51.033333333333331</c:v>
                </c:pt>
                <c:pt idx="35">
                  <c:v>55.93333333333333</c:v>
                </c:pt>
                <c:pt idx="36">
                  <c:v>59</c:v>
                </c:pt>
                <c:pt idx="37">
                  <c:v>60.56666666666667</c:v>
                </c:pt>
                <c:pt idx="38">
                  <c:v>60.866666666666667</c:v>
                </c:pt>
                <c:pt idx="39">
                  <c:v>62.466666666666669</c:v>
                </c:pt>
                <c:pt idx="40">
                  <c:v>65.033333333333331</c:v>
                </c:pt>
                <c:pt idx="41">
                  <c:v>70.933333333333337</c:v>
                </c:pt>
                <c:pt idx="42">
                  <c:v>70.933333333333337</c:v>
                </c:pt>
                <c:pt idx="43">
                  <c:v>73.533333333333331</c:v>
                </c:pt>
                <c:pt idx="44">
                  <c:v>75.3</c:v>
                </c:pt>
                <c:pt idx="45">
                  <c:v>76.066666666666663</c:v>
                </c:pt>
                <c:pt idx="46">
                  <c:v>77.166666666666671</c:v>
                </c:pt>
                <c:pt idx="47">
                  <c:v>77.599999999999994</c:v>
                </c:pt>
                <c:pt idx="48">
                  <c:v>79.599999999999994</c:v>
                </c:pt>
                <c:pt idx="49">
                  <c:v>84.63333333333334</c:v>
                </c:pt>
                <c:pt idx="50">
                  <c:v>98.033333333333331</c:v>
                </c:pt>
                <c:pt idx="51">
                  <c:v>101.33333333333333</c:v>
                </c:pt>
                <c:pt idx="52">
                  <c:v>106.46666666666667</c:v>
                </c:pt>
                <c:pt idx="53">
                  <c:v>107.16666666666667</c:v>
                </c:pt>
                <c:pt idx="54">
                  <c:v>111.1</c:v>
                </c:pt>
                <c:pt idx="55">
                  <c:v>111.3</c:v>
                </c:pt>
                <c:pt idx="56">
                  <c:v>114.9</c:v>
                </c:pt>
                <c:pt idx="57">
                  <c:v>119.76666666666667</c:v>
                </c:pt>
                <c:pt idx="58">
                  <c:v>120.23333333333333</c:v>
                </c:pt>
                <c:pt idx="59">
                  <c:v>121.2</c:v>
                </c:pt>
                <c:pt idx="60">
                  <c:v>121.23333333333333</c:v>
                </c:pt>
                <c:pt idx="61">
                  <c:v>121.93333333333334</c:v>
                </c:pt>
                <c:pt idx="62">
                  <c:v>134.6</c:v>
                </c:pt>
                <c:pt idx="63">
                  <c:v>139.73333333333332</c:v>
                </c:pt>
                <c:pt idx="64">
                  <c:v>140.43333333333334</c:v>
                </c:pt>
                <c:pt idx="65">
                  <c:v>143.53333333333333</c:v>
                </c:pt>
              </c:numCache>
            </c:numRef>
          </c:xVal>
          <c:yVal>
            <c:numRef>
              <c:f>作動月3群!$B$180:$B$245</c:f>
              <c:numCache>
                <c:formatCode>0.0000</c:formatCode>
                <c:ptCount val="66"/>
                <c:pt idx="0">
                  <c:v>1</c:v>
                </c:pt>
                <c:pt idx="1">
                  <c:v>1</c:v>
                </c:pt>
                <c:pt idx="2" formatCode="General">
                  <c:v>1</c:v>
                </c:pt>
                <c:pt idx="3">
                  <c:v>0.98305084745762716</c:v>
                </c:pt>
                <c:pt idx="4">
                  <c:v>0.98305084745762716</c:v>
                </c:pt>
                <c:pt idx="5">
                  <c:v>0.98305084745762716</c:v>
                </c:pt>
                <c:pt idx="6">
                  <c:v>0.98305084745762716</c:v>
                </c:pt>
                <c:pt idx="7">
                  <c:v>0.98305084745762716</c:v>
                </c:pt>
                <c:pt idx="8" formatCode="General">
                  <c:v>0.98305084745762716</c:v>
                </c:pt>
                <c:pt idx="9">
                  <c:v>0.9648462021343378</c:v>
                </c:pt>
                <c:pt idx="10">
                  <c:v>0.9648462021343378</c:v>
                </c:pt>
                <c:pt idx="11">
                  <c:v>0.9648462021343378</c:v>
                </c:pt>
                <c:pt idx="12">
                  <c:v>0.9648462021343378</c:v>
                </c:pt>
                <c:pt idx="13">
                  <c:v>0.9648462021343378</c:v>
                </c:pt>
                <c:pt idx="14">
                  <c:v>0.9648462021343378</c:v>
                </c:pt>
                <c:pt idx="15">
                  <c:v>0.9648462021343378</c:v>
                </c:pt>
                <c:pt idx="16">
                  <c:v>0.9648462021343378</c:v>
                </c:pt>
                <c:pt idx="17" formatCode="General">
                  <c:v>0.9648462021343378</c:v>
                </c:pt>
                <c:pt idx="18">
                  <c:v>0.94387128469663484</c:v>
                </c:pt>
                <c:pt idx="19">
                  <c:v>0.94387128469663484</c:v>
                </c:pt>
                <c:pt idx="20">
                  <c:v>0.94387128469663484</c:v>
                </c:pt>
                <c:pt idx="21">
                  <c:v>0.94387128469663484</c:v>
                </c:pt>
                <c:pt idx="22">
                  <c:v>0.94387128469663484</c:v>
                </c:pt>
                <c:pt idx="23">
                  <c:v>0.94387128469663484</c:v>
                </c:pt>
                <c:pt idx="24">
                  <c:v>0.94387128469663484</c:v>
                </c:pt>
                <c:pt idx="25" formatCode="General">
                  <c:v>0.94387128469663484</c:v>
                </c:pt>
                <c:pt idx="26">
                  <c:v>0.91966945688390056</c:v>
                </c:pt>
                <c:pt idx="27">
                  <c:v>0.91966945688390056</c:v>
                </c:pt>
                <c:pt idx="28">
                  <c:v>0.91966945688390056</c:v>
                </c:pt>
                <c:pt idx="29">
                  <c:v>0.91966945688390056</c:v>
                </c:pt>
                <c:pt idx="30">
                  <c:v>0.91966945688390056</c:v>
                </c:pt>
                <c:pt idx="31">
                  <c:v>0.91966945688390056</c:v>
                </c:pt>
                <c:pt idx="32">
                  <c:v>0.91966945688390056</c:v>
                </c:pt>
                <c:pt idx="33">
                  <c:v>0.91966945688390056</c:v>
                </c:pt>
                <c:pt idx="34">
                  <c:v>0.91966945688390056</c:v>
                </c:pt>
                <c:pt idx="35">
                  <c:v>0.91966945688390056</c:v>
                </c:pt>
                <c:pt idx="36">
                  <c:v>0.91966945688390056</c:v>
                </c:pt>
                <c:pt idx="37">
                  <c:v>0.91966945688390056</c:v>
                </c:pt>
                <c:pt idx="38">
                  <c:v>0.91966945688390056</c:v>
                </c:pt>
                <c:pt idx="39">
                  <c:v>0.91966945688390056</c:v>
                </c:pt>
                <c:pt idx="40">
                  <c:v>0.91966945688390056</c:v>
                </c:pt>
                <c:pt idx="41" formatCode="General">
                  <c:v>0.91966945688390056</c:v>
                </c:pt>
                <c:pt idx="42">
                  <c:v>0.88134989618040471</c:v>
                </c:pt>
                <c:pt idx="43">
                  <c:v>0.88134989618040471</c:v>
                </c:pt>
                <c:pt idx="44">
                  <c:v>0.88134989618040471</c:v>
                </c:pt>
                <c:pt idx="45">
                  <c:v>0.88134989618040471</c:v>
                </c:pt>
                <c:pt idx="46">
                  <c:v>0.88134989618040471</c:v>
                </c:pt>
                <c:pt idx="47">
                  <c:v>0.88134989618040471</c:v>
                </c:pt>
                <c:pt idx="48">
                  <c:v>0.88134989618040471</c:v>
                </c:pt>
                <c:pt idx="49">
                  <c:v>0.88134989618040471</c:v>
                </c:pt>
                <c:pt idx="50">
                  <c:v>0.88134989618040471</c:v>
                </c:pt>
                <c:pt idx="51">
                  <c:v>0.88134989618040471</c:v>
                </c:pt>
                <c:pt idx="52">
                  <c:v>0.88134989618040471</c:v>
                </c:pt>
                <c:pt idx="53">
                  <c:v>0.88134989618040471</c:v>
                </c:pt>
                <c:pt idx="54">
                  <c:v>0.88134989618040471</c:v>
                </c:pt>
                <c:pt idx="55">
                  <c:v>0.88134989618040471</c:v>
                </c:pt>
                <c:pt idx="56">
                  <c:v>0.88134989618040471</c:v>
                </c:pt>
                <c:pt idx="57">
                  <c:v>0.88134989618040471</c:v>
                </c:pt>
                <c:pt idx="58">
                  <c:v>0.88134989618040471</c:v>
                </c:pt>
                <c:pt idx="59">
                  <c:v>0.88134989618040471</c:v>
                </c:pt>
                <c:pt idx="60">
                  <c:v>0.88134989618040471</c:v>
                </c:pt>
                <c:pt idx="61">
                  <c:v>0.88134989618040471</c:v>
                </c:pt>
                <c:pt idx="62">
                  <c:v>0.88134989618040471</c:v>
                </c:pt>
                <c:pt idx="63">
                  <c:v>0.88134989618040471</c:v>
                </c:pt>
                <c:pt idx="64">
                  <c:v>0.88134989618040471</c:v>
                </c:pt>
                <c:pt idx="65">
                  <c:v>0.881349896180404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D00-44F6-A27D-012EA104BE5B}"/>
            </c:ext>
          </c:extLst>
        </c:ser>
        <c:ser>
          <c:idx val="1"/>
          <c:order val="1"/>
          <c:tx>
            <c:strRef>
              <c:f>作動月3群!$E$179</c:f>
              <c:strCache>
                <c:ptCount val="1"/>
                <c:pt idx="0">
                  <c:v>Class IIa</c:v>
                </c:pt>
              </c:strCache>
            </c:strRef>
          </c:tx>
          <c:spPr>
            <a:ln w="25400">
              <a:solidFill>
                <a:srgbClr val="C0504D"/>
              </a:solidFill>
              <a:prstDash val="solid"/>
            </a:ln>
          </c:spPr>
          <c:marker>
            <c:symbol val="none"/>
          </c:marker>
          <c:xVal>
            <c:numRef>
              <c:f>作動月3群!$D$180:$D$217</c:f>
              <c:numCache>
                <c:formatCode>General</c:formatCode>
                <c:ptCount val="38"/>
                <c:pt idx="0">
                  <c:v>0</c:v>
                </c:pt>
                <c:pt idx="1">
                  <c:v>2.9333333333333331</c:v>
                </c:pt>
                <c:pt idx="2">
                  <c:v>3.3333333333333335</c:v>
                </c:pt>
                <c:pt idx="3">
                  <c:v>3.3333333333333335</c:v>
                </c:pt>
                <c:pt idx="4">
                  <c:v>4.8666666666666663</c:v>
                </c:pt>
                <c:pt idx="5">
                  <c:v>4.8666666666666663</c:v>
                </c:pt>
                <c:pt idx="6">
                  <c:v>6.1</c:v>
                </c:pt>
                <c:pt idx="7">
                  <c:v>8.5</c:v>
                </c:pt>
                <c:pt idx="8">
                  <c:v>8.5</c:v>
                </c:pt>
                <c:pt idx="9">
                  <c:v>12.866666666666667</c:v>
                </c:pt>
                <c:pt idx="10">
                  <c:v>12.866666666666667</c:v>
                </c:pt>
                <c:pt idx="11">
                  <c:v>19.066666666666666</c:v>
                </c:pt>
                <c:pt idx="12">
                  <c:v>23.5</c:v>
                </c:pt>
                <c:pt idx="13">
                  <c:v>25.733333333333334</c:v>
                </c:pt>
                <c:pt idx="14">
                  <c:v>29.9</c:v>
                </c:pt>
                <c:pt idx="15">
                  <c:v>30.033333333333335</c:v>
                </c:pt>
                <c:pt idx="16">
                  <c:v>32.5</c:v>
                </c:pt>
                <c:pt idx="17">
                  <c:v>32.666666666666664</c:v>
                </c:pt>
                <c:pt idx="18">
                  <c:v>35.666666666666664</c:v>
                </c:pt>
                <c:pt idx="19">
                  <c:v>35.9</c:v>
                </c:pt>
                <c:pt idx="20">
                  <c:v>36.666666666666664</c:v>
                </c:pt>
                <c:pt idx="21">
                  <c:v>36.666666666666664</c:v>
                </c:pt>
                <c:pt idx="22">
                  <c:v>39.866666666666667</c:v>
                </c:pt>
                <c:pt idx="23">
                  <c:v>41.06666666666667</c:v>
                </c:pt>
                <c:pt idx="24">
                  <c:v>41.06666666666667</c:v>
                </c:pt>
                <c:pt idx="25">
                  <c:v>47.06666666666667</c:v>
                </c:pt>
                <c:pt idx="26">
                  <c:v>49.6</c:v>
                </c:pt>
                <c:pt idx="27">
                  <c:v>52.93333333333333</c:v>
                </c:pt>
                <c:pt idx="28">
                  <c:v>53.4</c:v>
                </c:pt>
                <c:pt idx="29">
                  <c:v>58.766666666666666</c:v>
                </c:pt>
                <c:pt idx="30">
                  <c:v>58.766666666666666</c:v>
                </c:pt>
                <c:pt idx="31">
                  <c:v>63.1</c:v>
                </c:pt>
                <c:pt idx="32">
                  <c:v>67.033333333333331</c:v>
                </c:pt>
                <c:pt idx="33">
                  <c:v>88.833333333333329</c:v>
                </c:pt>
                <c:pt idx="34">
                  <c:v>89</c:v>
                </c:pt>
                <c:pt idx="35">
                  <c:v>103.03333333333333</c:v>
                </c:pt>
                <c:pt idx="36">
                  <c:v>131.80000000000001</c:v>
                </c:pt>
                <c:pt idx="37">
                  <c:v>141.06666666666666</c:v>
                </c:pt>
              </c:numCache>
            </c:numRef>
          </c:xVal>
          <c:yVal>
            <c:numRef>
              <c:f>作動月3群!$E$180:$E$217</c:f>
              <c:numCache>
                <c:formatCode>0.0000</c:formatCode>
                <c:ptCount val="38"/>
                <c:pt idx="0">
                  <c:v>1</c:v>
                </c:pt>
                <c:pt idx="1">
                  <c:v>1</c:v>
                </c:pt>
                <c:pt idx="2" formatCode="General">
                  <c:v>1</c:v>
                </c:pt>
                <c:pt idx="3">
                  <c:v>0.96551724137931039</c:v>
                </c:pt>
                <c:pt idx="4" formatCode="General">
                  <c:v>0.96551724137931039</c:v>
                </c:pt>
                <c:pt idx="5">
                  <c:v>0.93103448275862077</c:v>
                </c:pt>
                <c:pt idx="6">
                  <c:v>0.93103448275862077</c:v>
                </c:pt>
                <c:pt idx="7" formatCode="General">
                  <c:v>0.93103448275862077</c:v>
                </c:pt>
                <c:pt idx="8">
                  <c:v>0.89522546419098159</c:v>
                </c:pt>
                <c:pt idx="9" formatCode="General">
                  <c:v>0.89522546419098159</c:v>
                </c:pt>
                <c:pt idx="10">
                  <c:v>0.8594164456233423</c:v>
                </c:pt>
                <c:pt idx="11">
                  <c:v>0.8594164456233423</c:v>
                </c:pt>
                <c:pt idx="12">
                  <c:v>0.8594164456233423</c:v>
                </c:pt>
                <c:pt idx="13">
                  <c:v>0.8594164456233423</c:v>
                </c:pt>
                <c:pt idx="14">
                  <c:v>0.8594164456233423</c:v>
                </c:pt>
                <c:pt idx="15">
                  <c:v>0.8594164456233423</c:v>
                </c:pt>
                <c:pt idx="16">
                  <c:v>0.8594164456233423</c:v>
                </c:pt>
                <c:pt idx="17">
                  <c:v>0.8594164456233423</c:v>
                </c:pt>
                <c:pt idx="18">
                  <c:v>0.8594164456233423</c:v>
                </c:pt>
                <c:pt idx="19">
                  <c:v>0.8594164456233423</c:v>
                </c:pt>
                <c:pt idx="20" formatCode="General">
                  <c:v>0.8594164456233423</c:v>
                </c:pt>
                <c:pt idx="21">
                  <c:v>0.80212201591511945</c:v>
                </c:pt>
                <c:pt idx="22">
                  <c:v>0.80212201591511945</c:v>
                </c:pt>
                <c:pt idx="23" formatCode="General">
                  <c:v>0.80212201591511945</c:v>
                </c:pt>
                <c:pt idx="24">
                  <c:v>0.74042032238318722</c:v>
                </c:pt>
                <c:pt idx="25">
                  <c:v>0.74042032238318722</c:v>
                </c:pt>
                <c:pt idx="26">
                  <c:v>0.74042032238318722</c:v>
                </c:pt>
                <c:pt idx="27">
                  <c:v>0.74042032238318722</c:v>
                </c:pt>
                <c:pt idx="28">
                  <c:v>0.74042032238318722</c:v>
                </c:pt>
                <c:pt idx="29" formatCode="General">
                  <c:v>0.74042032238318722</c:v>
                </c:pt>
                <c:pt idx="30">
                  <c:v>0.64786778208528883</c:v>
                </c:pt>
                <c:pt idx="31">
                  <c:v>0.64786778208528883</c:v>
                </c:pt>
                <c:pt idx="32">
                  <c:v>0.64786778208528883</c:v>
                </c:pt>
                <c:pt idx="33">
                  <c:v>0.64786778208528883</c:v>
                </c:pt>
                <c:pt idx="34">
                  <c:v>0.64786778208528883</c:v>
                </c:pt>
                <c:pt idx="35">
                  <c:v>0.64786778208528883</c:v>
                </c:pt>
                <c:pt idx="36">
                  <c:v>0.64786778208528883</c:v>
                </c:pt>
                <c:pt idx="37">
                  <c:v>0.647867782085288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D00-44F6-A27D-012EA104BE5B}"/>
            </c:ext>
          </c:extLst>
        </c:ser>
        <c:ser>
          <c:idx val="2"/>
          <c:order val="2"/>
          <c:tx>
            <c:strRef>
              <c:f>作動月3群!$H$179</c:f>
              <c:strCache>
                <c:ptCount val="1"/>
                <c:pt idx="0">
                  <c:v>Class IIb</c:v>
                </c:pt>
              </c:strCache>
            </c:strRef>
          </c:tx>
          <c:spPr>
            <a:ln w="25400">
              <a:solidFill>
                <a:srgbClr val="9BBB59"/>
              </a:solidFill>
              <a:prstDash val="solid"/>
            </a:ln>
          </c:spPr>
          <c:marker>
            <c:symbol val="none"/>
          </c:marker>
          <c:xVal>
            <c:numRef>
              <c:f>作動月3群!$G$180:$G$208</c:f>
              <c:numCache>
                <c:formatCode>General</c:formatCode>
                <c:ptCount val="29"/>
                <c:pt idx="0">
                  <c:v>0</c:v>
                </c:pt>
                <c:pt idx="1">
                  <c:v>5.8</c:v>
                </c:pt>
                <c:pt idx="2">
                  <c:v>6.7333333333333334</c:v>
                </c:pt>
                <c:pt idx="3">
                  <c:v>6.7333333333333334</c:v>
                </c:pt>
                <c:pt idx="4">
                  <c:v>9.8666666666666671</c:v>
                </c:pt>
                <c:pt idx="5">
                  <c:v>9.8666666666666671</c:v>
                </c:pt>
                <c:pt idx="6">
                  <c:v>24.966666666666665</c:v>
                </c:pt>
                <c:pt idx="7">
                  <c:v>25.8</c:v>
                </c:pt>
                <c:pt idx="8">
                  <c:v>29.833333333333332</c:v>
                </c:pt>
                <c:pt idx="9">
                  <c:v>31.166666666666668</c:v>
                </c:pt>
                <c:pt idx="10">
                  <c:v>31.166666666666668</c:v>
                </c:pt>
                <c:pt idx="11">
                  <c:v>33.333333333333336</c:v>
                </c:pt>
                <c:pt idx="12">
                  <c:v>34.033333333333331</c:v>
                </c:pt>
                <c:pt idx="13">
                  <c:v>34.533333333333331</c:v>
                </c:pt>
                <c:pt idx="14">
                  <c:v>36.133333333333333</c:v>
                </c:pt>
                <c:pt idx="15">
                  <c:v>40.1</c:v>
                </c:pt>
                <c:pt idx="16">
                  <c:v>41.733333333333334</c:v>
                </c:pt>
                <c:pt idx="17">
                  <c:v>45.133333333333333</c:v>
                </c:pt>
                <c:pt idx="18">
                  <c:v>46.06666666666667</c:v>
                </c:pt>
                <c:pt idx="19">
                  <c:v>49.8</c:v>
                </c:pt>
                <c:pt idx="20">
                  <c:v>56</c:v>
                </c:pt>
                <c:pt idx="21">
                  <c:v>58.866666666666667</c:v>
                </c:pt>
                <c:pt idx="22">
                  <c:v>74.3</c:v>
                </c:pt>
                <c:pt idx="23">
                  <c:v>77.333333333333329</c:v>
                </c:pt>
                <c:pt idx="24">
                  <c:v>77.333333333333329</c:v>
                </c:pt>
                <c:pt idx="25">
                  <c:v>83.13333333333334</c:v>
                </c:pt>
                <c:pt idx="26">
                  <c:v>87.5</c:v>
                </c:pt>
                <c:pt idx="27">
                  <c:v>107.5</c:v>
                </c:pt>
                <c:pt idx="28">
                  <c:v>115.3</c:v>
                </c:pt>
              </c:numCache>
            </c:numRef>
          </c:xVal>
          <c:yVal>
            <c:numRef>
              <c:f>作動月3群!$H$180:$H$208</c:f>
              <c:numCache>
                <c:formatCode>0.0000</c:formatCode>
                <c:ptCount val="29"/>
                <c:pt idx="0">
                  <c:v>1</c:v>
                </c:pt>
                <c:pt idx="1">
                  <c:v>1</c:v>
                </c:pt>
                <c:pt idx="2" formatCode="General">
                  <c:v>1</c:v>
                </c:pt>
                <c:pt idx="3">
                  <c:v>0.95652173913043481</c:v>
                </c:pt>
                <c:pt idx="4" formatCode="General">
                  <c:v>0.95652173913043481</c:v>
                </c:pt>
                <c:pt idx="5">
                  <c:v>0.91304347826086962</c:v>
                </c:pt>
                <c:pt idx="6">
                  <c:v>0.91304347826086962</c:v>
                </c:pt>
                <c:pt idx="7">
                  <c:v>0.91304347826086962</c:v>
                </c:pt>
                <c:pt idx="8">
                  <c:v>0.91304347826086962</c:v>
                </c:pt>
                <c:pt idx="9" formatCode="General">
                  <c:v>0.91304347826086962</c:v>
                </c:pt>
                <c:pt idx="10">
                  <c:v>0.8623188405797102</c:v>
                </c:pt>
                <c:pt idx="11">
                  <c:v>0.8623188405797102</c:v>
                </c:pt>
                <c:pt idx="12">
                  <c:v>0.8623188405797102</c:v>
                </c:pt>
                <c:pt idx="13">
                  <c:v>0.8623188405797102</c:v>
                </c:pt>
                <c:pt idx="14">
                  <c:v>0.8623188405797102</c:v>
                </c:pt>
                <c:pt idx="15">
                  <c:v>0.8623188405797102</c:v>
                </c:pt>
                <c:pt idx="16">
                  <c:v>0.8623188405797102</c:v>
                </c:pt>
                <c:pt idx="17">
                  <c:v>0.8623188405797102</c:v>
                </c:pt>
                <c:pt idx="18">
                  <c:v>0.8623188405797102</c:v>
                </c:pt>
                <c:pt idx="19">
                  <c:v>0.8623188405797102</c:v>
                </c:pt>
                <c:pt idx="20">
                  <c:v>0.8623188405797102</c:v>
                </c:pt>
                <c:pt idx="21">
                  <c:v>0.8623188405797102</c:v>
                </c:pt>
                <c:pt idx="22">
                  <c:v>0.8623188405797102</c:v>
                </c:pt>
                <c:pt idx="23" formatCode="General">
                  <c:v>0.8623188405797102</c:v>
                </c:pt>
                <c:pt idx="24">
                  <c:v>0.6898550724637682</c:v>
                </c:pt>
                <c:pt idx="25">
                  <c:v>0.6898550724637682</c:v>
                </c:pt>
                <c:pt idx="26">
                  <c:v>0.6898550724637682</c:v>
                </c:pt>
                <c:pt idx="27">
                  <c:v>0.6898550724637682</c:v>
                </c:pt>
                <c:pt idx="28">
                  <c:v>0.68985507246376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D00-44F6-A27D-012EA104BE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25006968"/>
        <c:axId val="1325009264"/>
      </c:scatterChart>
      <c:valAx>
        <c:axId val="13250069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altLang="ja-JP" sz="1100" dirty="0"/>
                  <a:t>Months</a:t>
                </a:r>
                <a:r>
                  <a:rPr lang="ja-JP" altLang="en-US" sz="1800" dirty="0"/>
                  <a:t> </a:t>
                </a:r>
              </a:p>
            </c:rich>
          </c:tx>
          <c:layout>
            <c:manualLayout>
              <c:xMode val="edge"/>
              <c:yMode val="edge"/>
              <c:x val="0.42198892447291164"/>
              <c:y val="0.9057065659930416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1325009264"/>
        <c:crosses val="autoZero"/>
        <c:crossBetween val="midCat"/>
        <c:majorUnit val="24"/>
      </c:valAx>
      <c:valAx>
        <c:axId val="1325009264"/>
        <c:scaling>
          <c:orientation val="minMax"/>
          <c:max val="1.100000000000000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altLang="ja-JP" sz="1100" dirty="0"/>
                  <a:t>Percent</a:t>
                </a:r>
                <a:r>
                  <a:rPr lang="ja-JP" altLang="en-US" sz="1100" dirty="0"/>
                  <a:t> 　</a:t>
                </a:r>
                <a:r>
                  <a:rPr lang="en-US" altLang="ja-JP" sz="1100" dirty="0"/>
                  <a:t>survival</a:t>
                </a:r>
                <a:endParaRPr lang="ja-JP" altLang="en-US" sz="1100" dirty="0"/>
              </a:p>
            </c:rich>
          </c:tx>
          <c:overlay val="0"/>
        </c:title>
        <c:numFmt formatCode="0.00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1325006968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ROC</a:t>
            </a:r>
            <a:r>
              <a:rPr lang="en-US" baseline="0" dirty="0"/>
              <a:t> curve (mortality)</a:t>
            </a:r>
            <a:endParaRPr lang="ja-JP" dirty="0"/>
          </a:p>
        </c:rich>
      </c:tx>
      <c:layout>
        <c:manualLayout>
          <c:xMode val="edge"/>
          <c:yMode val="edge"/>
          <c:x val="0.27564458140729325"/>
          <c:y val="4.5871559633027525E-2"/>
        </c:manualLayout>
      </c:layout>
      <c:overlay val="0"/>
    </c:title>
    <c:autoTitleDeleted val="0"/>
    <c:plotArea>
      <c:layout>
        <c:manualLayout>
          <c:xMode val="edge"/>
          <c:yMode val="edge"/>
          <c:x val="0.10197975253093364"/>
          <c:y val="0.18258994548758328"/>
          <c:w val="0.54861192350956134"/>
          <c:h val="0.68928164748637188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3!$A$45</c:f>
              <c:strCache>
                <c:ptCount val="1"/>
                <c:pt idx="0">
                  <c:v>QRS/LVEDV</c:v>
                </c:pt>
              </c:strCache>
            </c:strRef>
          </c:tx>
          <c:spPr>
            <a:ln>
              <a:solidFill>
                <a:srgbClr val="000080"/>
              </a:solidFill>
              <a:prstDash val="solid"/>
            </a:ln>
          </c:spPr>
          <c:marker>
            <c:spPr>
              <a:solidFill>
                <a:srgbClr val="000080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xVal>
            <c:numRef>
              <c:f>Sheet3!$B$47:$B$149</c:f>
              <c:numCache>
                <c:formatCode>0.0000</c:formatCode>
                <c:ptCount val="10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2500000000000001E-2</c:v>
                </c:pt>
                <c:pt idx="4">
                  <c:v>2.5000000000000001E-2</c:v>
                </c:pt>
                <c:pt idx="5">
                  <c:v>3.7499999999999999E-2</c:v>
                </c:pt>
                <c:pt idx="6">
                  <c:v>3.7499999999999999E-2</c:v>
                </c:pt>
                <c:pt idx="7">
                  <c:v>3.7499999999999999E-2</c:v>
                </c:pt>
                <c:pt idx="8">
                  <c:v>0.05</c:v>
                </c:pt>
                <c:pt idx="9">
                  <c:v>6.25E-2</c:v>
                </c:pt>
                <c:pt idx="10">
                  <c:v>7.4999999999999997E-2</c:v>
                </c:pt>
                <c:pt idx="11">
                  <c:v>8.7499999999999994E-2</c:v>
                </c:pt>
                <c:pt idx="12">
                  <c:v>8.7499999999999994E-2</c:v>
                </c:pt>
                <c:pt idx="13">
                  <c:v>0.1</c:v>
                </c:pt>
                <c:pt idx="14">
                  <c:v>0.1125</c:v>
                </c:pt>
                <c:pt idx="15">
                  <c:v>0.125</c:v>
                </c:pt>
                <c:pt idx="16">
                  <c:v>0.13750000000000001</c:v>
                </c:pt>
                <c:pt idx="17">
                  <c:v>0.15</c:v>
                </c:pt>
                <c:pt idx="18">
                  <c:v>0.16250000000000001</c:v>
                </c:pt>
                <c:pt idx="19">
                  <c:v>0.17499999999999999</c:v>
                </c:pt>
                <c:pt idx="20">
                  <c:v>0.1875</c:v>
                </c:pt>
                <c:pt idx="21">
                  <c:v>0.2</c:v>
                </c:pt>
                <c:pt idx="22">
                  <c:v>0.21249999999999999</c:v>
                </c:pt>
                <c:pt idx="23">
                  <c:v>0.21249999999999999</c:v>
                </c:pt>
                <c:pt idx="24">
                  <c:v>0.21249999999999999</c:v>
                </c:pt>
                <c:pt idx="25">
                  <c:v>0.21249999999999999</c:v>
                </c:pt>
                <c:pt idx="26">
                  <c:v>0.22500000000000001</c:v>
                </c:pt>
                <c:pt idx="27">
                  <c:v>0.23749999999999999</c:v>
                </c:pt>
                <c:pt idx="28">
                  <c:v>0.25</c:v>
                </c:pt>
                <c:pt idx="29">
                  <c:v>0.26250000000000001</c:v>
                </c:pt>
                <c:pt idx="30">
                  <c:v>0.27500000000000002</c:v>
                </c:pt>
                <c:pt idx="31">
                  <c:v>0.27500000000000002</c:v>
                </c:pt>
                <c:pt idx="32">
                  <c:v>0.28749999999999998</c:v>
                </c:pt>
                <c:pt idx="33">
                  <c:v>0.3</c:v>
                </c:pt>
                <c:pt idx="34">
                  <c:v>0.32500000000000001</c:v>
                </c:pt>
                <c:pt idx="35">
                  <c:v>0.32500000000000001</c:v>
                </c:pt>
                <c:pt idx="36">
                  <c:v>0.33750000000000002</c:v>
                </c:pt>
                <c:pt idx="37">
                  <c:v>0.35</c:v>
                </c:pt>
                <c:pt idx="38">
                  <c:v>0.36249999999999999</c:v>
                </c:pt>
                <c:pt idx="39">
                  <c:v>0.375</c:v>
                </c:pt>
                <c:pt idx="40">
                  <c:v>0.38750000000000001</c:v>
                </c:pt>
                <c:pt idx="41">
                  <c:v>0.38750000000000001</c:v>
                </c:pt>
                <c:pt idx="42">
                  <c:v>0.4</c:v>
                </c:pt>
                <c:pt idx="43">
                  <c:v>0.4</c:v>
                </c:pt>
                <c:pt idx="44">
                  <c:v>0.4</c:v>
                </c:pt>
                <c:pt idx="45">
                  <c:v>0.41249999999999998</c:v>
                </c:pt>
                <c:pt idx="46">
                  <c:v>0.41249999999999998</c:v>
                </c:pt>
                <c:pt idx="47">
                  <c:v>0.41249999999999998</c:v>
                </c:pt>
                <c:pt idx="48">
                  <c:v>0.41249999999999998</c:v>
                </c:pt>
                <c:pt idx="49">
                  <c:v>0.42499999999999999</c:v>
                </c:pt>
                <c:pt idx="50">
                  <c:v>0.42499999999999999</c:v>
                </c:pt>
                <c:pt idx="51">
                  <c:v>0.4375</c:v>
                </c:pt>
                <c:pt idx="52">
                  <c:v>0.45</c:v>
                </c:pt>
                <c:pt idx="53">
                  <c:v>0.46250000000000002</c:v>
                </c:pt>
                <c:pt idx="54">
                  <c:v>0.47499999999999998</c:v>
                </c:pt>
                <c:pt idx="55">
                  <c:v>0.48749999999999999</c:v>
                </c:pt>
                <c:pt idx="56">
                  <c:v>0.5</c:v>
                </c:pt>
                <c:pt idx="57">
                  <c:v>0.51249999999999996</c:v>
                </c:pt>
                <c:pt idx="58">
                  <c:v>0.52500000000000002</c:v>
                </c:pt>
                <c:pt idx="59">
                  <c:v>0.52500000000000002</c:v>
                </c:pt>
                <c:pt idx="60">
                  <c:v>0.53749999999999998</c:v>
                </c:pt>
                <c:pt idx="61">
                  <c:v>0.55000000000000004</c:v>
                </c:pt>
                <c:pt idx="62">
                  <c:v>0.5625</c:v>
                </c:pt>
                <c:pt idx="63">
                  <c:v>0.57499999999999996</c:v>
                </c:pt>
                <c:pt idx="64">
                  <c:v>0.57499999999999996</c:v>
                </c:pt>
                <c:pt idx="65">
                  <c:v>0.58750000000000002</c:v>
                </c:pt>
                <c:pt idx="66">
                  <c:v>0.58750000000000002</c:v>
                </c:pt>
                <c:pt idx="67">
                  <c:v>0.6</c:v>
                </c:pt>
                <c:pt idx="68">
                  <c:v>0.6</c:v>
                </c:pt>
                <c:pt idx="69">
                  <c:v>0.61250000000000004</c:v>
                </c:pt>
                <c:pt idx="70">
                  <c:v>0.625</c:v>
                </c:pt>
                <c:pt idx="71">
                  <c:v>0.625</c:v>
                </c:pt>
                <c:pt idx="72">
                  <c:v>0.625</c:v>
                </c:pt>
                <c:pt idx="73">
                  <c:v>0.63749999999999996</c:v>
                </c:pt>
                <c:pt idx="74">
                  <c:v>0.65</c:v>
                </c:pt>
                <c:pt idx="75">
                  <c:v>0.66249999999999998</c:v>
                </c:pt>
                <c:pt idx="76">
                  <c:v>0.67500000000000004</c:v>
                </c:pt>
                <c:pt idx="77">
                  <c:v>0.6875</c:v>
                </c:pt>
                <c:pt idx="78">
                  <c:v>0.71250000000000002</c:v>
                </c:pt>
                <c:pt idx="79">
                  <c:v>0.72499999999999998</c:v>
                </c:pt>
                <c:pt idx="80">
                  <c:v>0.73750000000000004</c:v>
                </c:pt>
                <c:pt idx="81">
                  <c:v>0.75</c:v>
                </c:pt>
                <c:pt idx="82">
                  <c:v>0.76249999999999996</c:v>
                </c:pt>
                <c:pt idx="83">
                  <c:v>0.77500000000000002</c:v>
                </c:pt>
                <c:pt idx="84">
                  <c:v>0.78749999999999998</c:v>
                </c:pt>
                <c:pt idx="85">
                  <c:v>0.8</c:v>
                </c:pt>
                <c:pt idx="86">
                  <c:v>0.8</c:v>
                </c:pt>
                <c:pt idx="87">
                  <c:v>0.8125</c:v>
                </c:pt>
                <c:pt idx="88">
                  <c:v>0.82499999999999996</c:v>
                </c:pt>
                <c:pt idx="89">
                  <c:v>0.83750000000000002</c:v>
                </c:pt>
                <c:pt idx="90">
                  <c:v>0.83750000000000002</c:v>
                </c:pt>
                <c:pt idx="91">
                  <c:v>0.85</c:v>
                </c:pt>
                <c:pt idx="92">
                  <c:v>0.86250000000000004</c:v>
                </c:pt>
                <c:pt idx="93">
                  <c:v>0.875</c:v>
                </c:pt>
                <c:pt idx="94">
                  <c:v>0.88749999999999996</c:v>
                </c:pt>
                <c:pt idx="95">
                  <c:v>0.9</c:v>
                </c:pt>
                <c:pt idx="96">
                  <c:v>0.91249999999999998</c:v>
                </c:pt>
                <c:pt idx="97">
                  <c:v>0.9375</c:v>
                </c:pt>
                <c:pt idx="98">
                  <c:v>0.95</c:v>
                </c:pt>
                <c:pt idx="99">
                  <c:v>0.96250000000000002</c:v>
                </c:pt>
                <c:pt idx="100">
                  <c:v>0.97499999999999998</c:v>
                </c:pt>
                <c:pt idx="101">
                  <c:v>0.98750000000000004</c:v>
                </c:pt>
                <c:pt idx="102">
                  <c:v>1</c:v>
                </c:pt>
              </c:numCache>
            </c:numRef>
          </c:xVal>
          <c:yVal>
            <c:numRef>
              <c:f>Sheet3!$C$47:$C$149</c:f>
              <c:numCache>
                <c:formatCode>0.0000</c:formatCode>
                <c:ptCount val="103"/>
                <c:pt idx="0">
                  <c:v>0</c:v>
                </c:pt>
                <c:pt idx="1">
                  <c:v>3.8461538461538464E-2</c:v>
                </c:pt>
                <c:pt idx="2">
                  <c:v>7.6923076923076927E-2</c:v>
                </c:pt>
                <c:pt idx="3">
                  <c:v>7.6923076923076927E-2</c:v>
                </c:pt>
                <c:pt idx="4">
                  <c:v>7.6923076923076927E-2</c:v>
                </c:pt>
                <c:pt idx="5">
                  <c:v>7.6923076923076927E-2</c:v>
                </c:pt>
                <c:pt idx="6">
                  <c:v>0.11538461538461539</c:v>
                </c:pt>
                <c:pt idx="7">
                  <c:v>0.15384615384615385</c:v>
                </c:pt>
                <c:pt idx="8">
                  <c:v>0.15384615384615385</c:v>
                </c:pt>
                <c:pt idx="9">
                  <c:v>0.15384615384615385</c:v>
                </c:pt>
                <c:pt idx="10">
                  <c:v>0.15384615384615385</c:v>
                </c:pt>
                <c:pt idx="11">
                  <c:v>0.15384615384615385</c:v>
                </c:pt>
                <c:pt idx="12">
                  <c:v>0.19230769230769232</c:v>
                </c:pt>
                <c:pt idx="13">
                  <c:v>0.19230769230769232</c:v>
                </c:pt>
                <c:pt idx="14">
                  <c:v>0.19230769230769232</c:v>
                </c:pt>
                <c:pt idx="15">
                  <c:v>0.19230769230769232</c:v>
                </c:pt>
                <c:pt idx="16">
                  <c:v>0.19230769230769232</c:v>
                </c:pt>
                <c:pt idx="17">
                  <c:v>0.19230769230769232</c:v>
                </c:pt>
                <c:pt idx="18">
                  <c:v>0.19230769230769232</c:v>
                </c:pt>
                <c:pt idx="19">
                  <c:v>0.19230769230769232</c:v>
                </c:pt>
                <c:pt idx="20">
                  <c:v>0.19230769230769232</c:v>
                </c:pt>
                <c:pt idx="21">
                  <c:v>0.19230769230769232</c:v>
                </c:pt>
                <c:pt idx="22">
                  <c:v>0.19230769230769232</c:v>
                </c:pt>
                <c:pt idx="23">
                  <c:v>0.23076923076923078</c:v>
                </c:pt>
                <c:pt idx="24">
                  <c:v>0.26923076923076922</c:v>
                </c:pt>
                <c:pt idx="25">
                  <c:v>0.30769230769230771</c:v>
                </c:pt>
                <c:pt idx="26">
                  <c:v>0.30769230769230771</c:v>
                </c:pt>
                <c:pt idx="27">
                  <c:v>0.30769230769230771</c:v>
                </c:pt>
                <c:pt idx="28">
                  <c:v>0.30769230769230771</c:v>
                </c:pt>
                <c:pt idx="29">
                  <c:v>0.30769230769230771</c:v>
                </c:pt>
                <c:pt idx="30">
                  <c:v>0.30769230769230771</c:v>
                </c:pt>
                <c:pt idx="31">
                  <c:v>0.34615384615384615</c:v>
                </c:pt>
                <c:pt idx="32">
                  <c:v>0.34615384615384615</c:v>
                </c:pt>
                <c:pt idx="33">
                  <c:v>0.34615384615384615</c:v>
                </c:pt>
                <c:pt idx="34">
                  <c:v>0.34615384615384615</c:v>
                </c:pt>
                <c:pt idx="35">
                  <c:v>0.38461538461538464</c:v>
                </c:pt>
                <c:pt idx="36">
                  <c:v>0.38461538461538464</c:v>
                </c:pt>
                <c:pt idx="37">
                  <c:v>0.38461538461538464</c:v>
                </c:pt>
                <c:pt idx="38">
                  <c:v>0.42307692307692307</c:v>
                </c:pt>
                <c:pt idx="39">
                  <c:v>0.42307692307692307</c:v>
                </c:pt>
                <c:pt idx="40">
                  <c:v>0.42307692307692307</c:v>
                </c:pt>
                <c:pt idx="41">
                  <c:v>0.46153846153846156</c:v>
                </c:pt>
                <c:pt idx="42">
                  <c:v>0.46153846153846156</c:v>
                </c:pt>
                <c:pt idx="43">
                  <c:v>0.5</c:v>
                </c:pt>
                <c:pt idx="44">
                  <c:v>0.53846153846153844</c:v>
                </c:pt>
                <c:pt idx="45">
                  <c:v>0.53846153846153844</c:v>
                </c:pt>
                <c:pt idx="46">
                  <c:v>0.57692307692307687</c:v>
                </c:pt>
                <c:pt idx="47">
                  <c:v>0.61538461538461542</c:v>
                </c:pt>
                <c:pt idx="48">
                  <c:v>0.65384615384615385</c:v>
                </c:pt>
                <c:pt idx="49">
                  <c:v>0.65384615384615385</c:v>
                </c:pt>
                <c:pt idx="50">
                  <c:v>0.69230769230769229</c:v>
                </c:pt>
                <c:pt idx="51">
                  <c:v>0.69230769230769229</c:v>
                </c:pt>
                <c:pt idx="52">
                  <c:v>0.69230769230769229</c:v>
                </c:pt>
                <c:pt idx="53">
                  <c:v>0.69230769230769229</c:v>
                </c:pt>
                <c:pt idx="54">
                  <c:v>0.69230769230769229</c:v>
                </c:pt>
                <c:pt idx="55">
                  <c:v>0.69230769230769229</c:v>
                </c:pt>
                <c:pt idx="56">
                  <c:v>0.69230769230769229</c:v>
                </c:pt>
                <c:pt idx="57">
                  <c:v>0.69230769230769229</c:v>
                </c:pt>
                <c:pt idx="58">
                  <c:v>0.69230769230769229</c:v>
                </c:pt>
                <c:pt idx="59">
                  <c:v>0.73076923076923073</c:v>
                </c:pt>
                <c:pt idx="60">
                  <c:v>0.73076923076923073</c:v>
                </c:pt>
                <c:pt idx="61">
                  <c:v>0.73076923076923073</c:v>
                </c:pt>
                <c:pt idx="62">
                  <c:v>0.73076923076923073</c:v>
                </c:pt>
                <c:pt idx="63">
                  <c:v>0.73076923076923073</c:v>
                </c:pt>
                <c:pt idx="64">
                  <c:v>0.76923076923076927</c:v>
                </c:pt>
                <c:pt idx="65">
                  <c:v>0.76923076923076927</c:v>
                </c:pt>
                <c:pt idx="66">
                  <c:v>0.80769230769230771</c:v>
                </c:pt>
                <c:pt idx="67">
                  <c:v>0.80769230769230771</c:v>
                </c:pt>
                <c:pt idx="68">
                  <c:v>0.84615384615384615</c:v>
                </c:pt>
                <c:pt idx="69">
                  <c:v>0.84615384615384615</c:v>
                </c:pt>
                <c:pt idx="70">
                  <c:v>0.84615384615384615</c:v>
                </c:pt>
                <c:pt idx="71">
                  <c:v>0.88461538461538458</c:v>
                </c:pt>
                <c:pt idx="72">
                  <c:v>0.92307692307692313</c:v>
                </c:pt>
                <c:pt idx="73">
                  <c:v>0.92307692307692313</c:v>
                </c:pt>
                <c:pt idx="74">
                  <c:v>0.92307692307692313</c:v>
                </c:pt>
                <c:pt idx="75">
                  <c:v>0.92307692307692313</c:v>
                </c:pt>
                <c:pt idx="76">
                  <c:v>0.92307692307692313</c:v>
                </c:pt>
                <c:pt idx="77">
                  <c:v>0.92307692307692313</c:v>
                </c:pt>
                <c:pt idx="78">
                  <c:v>0.92307692307692313</c:v>
                </c:pt>
                <c:pt idx="79">
                  <c:v>0.92307692307692313</c:v>
                </c:pt>
                <c:pt idx="80">
                  <c:v>0.92307692307692313</c:v>
                </c:pt>
                <c:pt idx="81">
                  <c:v>0.92307692307692313</c:v>
                </c:pt>
                <c:pt idx="82">
                  <c:v>0.92307692307692313</c:v>
                </c:pt>
                <c:pt idx="83">
                  <c:v>0.92307692307692313</c:v>
                </c:pt>
                <c:pt idx="84">
                  <c:v>0.92307692307692313</c:v>
                </c:pt>
                <c:pt idx="85">
                  <c:v>0.92307692307692313</c:v>
                </c:pt>
                <c:pt idx="86">
                  <c:v>0.96153846153846156</c:v>
                </c:pt>
                <c:pt idx="87">
                  <c:v>0.96153846153846156</c:v>
                </c:pt>
                <c:pt idx="88">
                  <c:v>0.96153846153846156</c:v>
                </c:pt>
                <c:pt idx="89">
                  <c:v>0.96153846153846156</c:v>
                </c:pt>
                <c:pt idx="90">
                  <c:v>1</c:v>
                </c:pt>
                <c:pt idx="91">
                  <c:v>1</c:v>
                </c:pt>
                <c:pt idx="92">
                  <c:v>1</c:v>
                </c:pt>
                <c:pt idx="93">
                  <c:v>1</c:v>
                </c:pt>
                <c:pt idx="94">
                  <c:v>1</c:v>
                </c:pt>
                <c:pt idx="95">
                  <c:v>1</c:v>
                </c:pt>
                <c:pt idx="96">
                  <c:v>1</c:v>
                </c:pt>
                <c:pt idx="97">
                  <c:v>1</c:v>
                </c:pt>
                <c:pt idx="98">
                  <c:v>1</c:v>
                </c:pt>
                <c:pt idx="99">
                  <c:v>1</c:v>
                </c:pt>
                <c:pt idx="100">
                  <c:v>1</c:v>
                </c:pt>
                <c:pt idx="101">
                  <c:v>1</c:v>
                </c:pt>
                <c:pt idx="102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A69-4C1B-A70D-F1FA309533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39395904"/>
        <c:axId val="947003448"/>
      </c:scatterChart>
      <c:valAx>
        <c:axId val="939395904"/>
        <c:scaling>
          <c:orientation val="minMax"/>
          <c:max val="1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altLang="ja-JP" sz="1600" dirty="0"/>
                  <a:t>1-Speciyity</a:t>
                </a:r>
                <a:endParaRPr lang="ja-JP" sz="1600" dirty="0"/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crossAx val="947003448"/>
        <c:crosses val="autoZero"/>
        <c:crossBetween val="midCat"/>
        <c:majorUnit val="0.2"/>
      </c:valAx>
      <c:valAx>
        <c:axId val="947003448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altLang="ja-JP" sz="1600" dirty="0"/>
                  <a:t>Sensitivity</a:t>
                </a:r>
                <a:endParaRPr lang="ja-JP" sz="1600" dirty="0"/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crossAx val="939395904"/>
        <c:crosses val="autoZero"/>
        <c:crossBetween val="midCat"/>
        <c:majorUnit val="0.2"/>
      </c:valAx>
      <c:spPr>
        <a:noFill/>
      </c:spPr>
    </c:plotArea>
    <c:legend>
      <c:legendPos val="r"/>
      <c:overlay val="0"/>
      <c:txPr>
        <a:bodyPr/>
        <a:lstStyle/>
        <a:p>
          <a:pPr>
            <a:defRPr sz="2000"/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12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2000"/>
            </a:pPr>
            <a:r>
              <a:rPr lang="en-US" altLang="ja-JP" sz="2000" dirty="0"/>
              <a:t>Appropriate ICD</a:t>
            </a:r>
            <a:r>
              <a:rPr lang="en-US" altLang="ja-JP" sz="2000" baseline="0" dirty="0"/>
              <a:t> therapy</a:t>
            </a:r>
            <a:endParaRPr lang="ja-JP" altLang="en-US" sz="2000" dirty="0"/>
          </a:p>
        </c:rich>
      </c:tx>
      <c:layout>
        <c:manualLayout>
          <c:xMode val="edge"/>
          <c:yMode val="edge"/>
          <c:x val="0.31463626456720933"/>
          <c:y val="1.645199496631875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9.2913775464816301E-2"/>
          <c:y val="0.12818454363757495"/>
          <c:w val="0.71796570589805175"/>
          <c:h val="0.74187190021467175"/>
        </c:manualLayout>
      </c:layout>
      <c:scatterChart>
        <c:scatterStyle val="lineMarker"/>
        <c:varyColors val="0"/>
        <c:ser>
          <c:idx val="0"/>
          <c:order val="0"/>
          <c:tx>
            <c:strRef>
              <c:f>作動月LVE!$B$165</c:f>
              <c:strCache>
                <c:ptCount val="1"/>
                <c:pt idx="0">
                  <c:v>QRS/LVEDV ≤0.66</c:v>
                </c:pt>
              </c:strCache>
            </c:strRef>
          </c:tx>
          <c:spPr>
            <a:ln w="25400">
              <a:solidFill>
                <a:srgbClr val="4F81BD"/>
              </a:solidFill>
              <a:prstDash val="solid"/>
            </a:ln>
          </c:spPr>
          <c:marker>
            <c:symbol val="none"/>
          </c:marker>
          <c:xVal>
            <c:numRef>
              <c:f>作動月LVE!$A$166:$A$228</c:f>
              <c:numCache>
                <c:formatCode>General</c:formatCode>
                <c:ptCount val="63"/>
                <c:pt idx="0">
                  <c:v>0</c:v>
                </c:pt>
                <c:pt idx="1">
                  <c:v>1.1666666666666667</c:v>
                </c:pt>
                <c:pt idx="2">
                  <c:v>3.3333333333333335</c:v>
                </c:pt>
                <c:pt idx="3">
                  <c:v>3.3333333333333335</c:v>
                </c:pt>
                <c:pt idx="4">
                  <c:v>4.8666666666666663</c:v>
                </c:pt>
                <c:pt idx="5">
                  <c:v>4.8666666666666663</c:v>
                </c:pt>
                <c:pt idx="6">
                  <c:v>6.1</c:v>
                </c:pt>
                <c:pt idx="7">
                  <c:v>6.7333333333333334</c:v>
                </c:pt>
                <c:pt idx="8">
                  <c:v>6.7333333333333334</c:v>
                </c:pt>
                <c:pt idx="9">
                  <c:v>8.9333333333333336</c:v>
                </c:pt>
                <c:pt idx="10">
                  <c:v>8.9333333333333336</c:v>
                </c:pt>
                <c:pt idx="11">
                  <c:v>16.366666666666667</c:v>
                </c:pt>
                <c:pt idx="12">
                  <c:v>16.366666666666667</c:v>
                </c:pt>
                <c:pt idx="13">
                  <c:v>18.899999999999999</c:v>
                </c:pt>
                <c:pt idx="14">
                  <c:v>19.333333333333332</c:v>
                </c:pt>
                <c:pt idx="15">
                  <c:v>21.433333333333334</c:v>
                </c:pt>
                <c:pt idx="16">
                  <c:v>23.5</c:v>
                </c:pt>
                <c:pt idx="17">
                  <c:v>23.5</c:v>
                </c:pt>
                <c:pt idx="18">
                  <c:v>24.633333333333333</c:v>
                </c:pt>
                <c:pt idx="19">
                  <c:v>24.966666666666665</c:v>
                </c:pt>
                <c:pt idx="20">
                  <c:v>29.9</c:v>
                </c:pt>
                <c:pt idx="21">
                  <c:v>31.166666666666668</c:v>
                </c:pt>
                <c:pt idx="22">
                  <c:v>31.166666666666668</c:v>
                </c:pt>
                <c:pt idx="23">
                  <c:v>32.5</c:v>
                </c:pt>
                <c:pt idx="24">
                  <c:v>34.533333333333331</c:v>
                </c:pt>
                <c:pt idx="25">
                  <c:v>36.133333333333333</c:v>
                </c:pt>
                <c:pt idx="26">
                  <c:v>36.533333333333331</c:v>
                </c:pt>
                <c:pt idx="27">
                  <c:v>36.666666666666664</c:v>
                </c:pt>
                <c:pt idx="28">
                  <c:v>36.666666666666664</c:v>
                </c:pt>
                <c:pt idx="29">
                  <c:v>36.866666666666667</c:v>
                </c:pt>
                <c:pt idx="30">
                  <c:v>39.866666666666667</c:v>
                </c:pt>
                <c:pt idx="31">
                  <c:v>41.06666666666667</c:v>
                </c:pt>
                <c:pt idx="32">
                  <c:v>41.06666666666667</c:v>
                </c:pt>
                <c:pt idx="33">
                  <c:v>42</c:v>
                </c:pt>
                <c:pt idx="34">
                  <c:v>42</c:v>
                </c:pt>
                <c:pt idx="35">
                  <c:v>42.5</c:v>
                </c:pt>
                <c:pt idx="36">
                  <c:v>46.233333333333334</c:v>
                </c:pt>
                <c:pt idx="37">
                  <c:v>49.6</c:v>
                </c:pt>
                <c:pt idx="38">
                  <c:v>49.666666666666664</c:v>
                </c:pt>
                <c:pt idx="39">
                  <c:v>49.8</c:v>
                </c:pt>
                <c:pt idx="40">
                  <c:v>51.033333333333331</c:v>
                </c:pt>
                <c:pt idx="41">
                  <c:v>52.93333333333333</c:v>
                </c:pt>
                <c:pt idx="42">
                  <c:v>55.93333333333333</c:v>
                </c:pt>
                <c:pt idx="43">
                  <c:v>58.866666666666667</c:v>
                </c:pt>
                <c:pt idx="44">
                  <c:v>62.466666666666669</c:v>
                </c:pt>
                <c:pt idx="45">
                  <c:v>63.1</c:v>
                </c:pt>
                <c:pt idx="46">
                  <c:v>73.533333333333331</c:v>
                </c:pt>
                <c:pt idx="47">
                  <c:v>74.3</c:v>
                </c:pt>
                <c:pt idx="48">
                  <c:v>77.166666666666671</c:v>
                </c:pt>
                <c:pt idx="49">
                  <c:v>77.333333333333329</c:v>
                </c:pt>
                <c:pt idx="50">
                  <c:v>77.333333333333329</c:v>
                </c:pt>
                <c:pt idx="51">
                  <c:v>84.63333333333334</c:v>
                </c:pt>
                <c:pt idx="52">
                  <c:v>98.033333333333331</c:v>
                </c:pt>
                <c:pt idx="53">
                  <c:v>101.33333333333333</c:v>
                </c:pt>
                <c:pt idx="54">
                  <c:v>106.46666666666667</c:v>
                </c:pt>
                <c:pt idx="55">
                  <c:v>107.16666666666667</c:v>
                </c:pt>
                <c:pt idx="56">
                  <c:v>111.1</c:v>
                </c:pt>
                <c:pt idx="57">
                  <c:v>114.9</c:v>
                </c:pt>
                <c:pt idx="58">
                  <c:v>121.2</c:v>
                </c:pt>
                <c:pt idx="59">
                  <c:v>121.23333333333333</c:v>
                </c:pt>
                <c:pt idx="60">
                  <c:v>134.6</c:v>
                </c:pt>
                <c:pt idx="61">
                  <c:v>140.43333333333334</c:v>
                </c:pt>
                <c:pt idx="62">
                  <c:v>143.53333333333333</c:v>
                </c:pt>
              </c:numCache>
            </c:numRef>
          </c:xVal>
          <c:yVal>
            <c:numRef>
              <c:f>作動月LVE!$B$166:$B$228</c:f>
              <c:numCache>
                <c:formatCode>0.0000</c:formatCode>
                <c:ptCount val="63"/>
                <c:pt idx="0">
                  <c:v>1</c:v>
                </c:pt>
                <c:pt idx="1">
                  <c:v>1</c:v>
                </c:pt>
                <c:pt idx="2" formatCode="General">
                  <c:v>1</c:v>
                </c:pt>
                <c:pt idx="3">
                  <c:v>0.98039215686274506</c:v>
                </c:pt>
                <c:pt idx="4" formatCode="General">
                  <c:v>0.98039215686274506</c:v>
                </c:pt>
                <c:pt idx="5">
                  <c:v>0.96078431372549011</c:v>
                </c:pt>
                <c:pt idx="6">
                  <c:v>0.96078431372549011</c:v>
                </c:pt>
                <c:pt idx="7" formatCode="General">
                  <c:v>0.96078431372549011</c:v>
                </c:pt>
                <c:pt idx="8">
                  <c:v>0.94076797385620903</c:v>
                </c:pt>
                <c:pt idx="9" formatCode="General">
                  <c:v>0.94076797385620903</c:v>
                </c:pt>
                <c:pt idx="10">
                  <c:v>0.92075163398692794</c:v>
                </c:pt>
                <c:pt idx="11" formatCode="General">
                  <c:v>0.92075163398692794</c:v>
                </c:pt>
                <c:pt idx="12">
                  <c:v>0.90073529411764697</c:v>
                </c:pt>
                <c:pt idx="13">
                  <c:v>0.90073529411764697</c:v>
                </c:pt>
                <c:pt idx="14">
                  <c:v>0.90073529411764697</c:v>
                </c:pt>
                <c:pt idx="15">
                  <c:v>0.90073529411764697</c:v>
                </c:pt>
                <c:pt idx="16">
                  <c:v>0.90073529411764697</c:v>
                </c:pt>
                <c:pt idx="17">
                  <c:v>0.90073529411764697</c:v>
                </c:pt>
                <c:pt idx="18">
                  <c:v>0.90073529411764697</c:v>
                </c:pt>
                <c:pt idx="19">
                  <c:v>0.90073529411764697</c:v>
                </c:pt>
                <c:pt idx="20">
                  <c:v>0.90073529411764697</c:v>
                </c:pt>
                <c:pt idx="21" formatCode="General">
                  <c:v>0.90073529411764697</c:v>
                </c:pt>
                <c:pt idx="22">
                  <c:v>0.87639109697933226</c:v>
                </c:pt>
                <c:pt idx="23">
                  <c:v>0.87639109697933226</c:v>
                </c:pt>
                <c:pt idx="24">
                  <c:v>0.87639109697933226</c:v>
                </c:pt>
                <c:pt idx="25">
                  <c:v>0.87639109697933226</c:v>
                </c:pt>
                <c:pt idx="26">
                  <c:v>0.87639109697933226</c:v>
                </c:pt>
                <c:pt idx="27" formatCode="General">
                  <c:v>0.87639109697933226</c:v>
                </c:pt>
                <c:pt idx="28">
                  <c:v>0.84900387519872811</c:v>
                </c:pt>
                <c:pt idx="29">
                  <c:v>0.84900387519872811</c:v>
                </c:pt>
                <c:pt idx="30">
                  <c:v>0.84900387519872811</c:v>
                </c:pt>
                <c:pt idx="31" formatCode="General">
                  <c:v>0.84900387519872811</c:v>
                </c:pt>
                <c:pt idx="32">
                  <c:v>0.81972787950222026</c:v>
                </c:pt>
                <c:pt idx="33" formatCode="General">
                  <c:v>0.81972787950222026</c:v>
                </c:pt>
                <c:pt idx="34">
                  <c:v>0.79045188380571241</c:v>
                </c:pt>
                <c:pt idx="35">
                  <c:v>0.79045188380571241</c:v>
                </c:pt>
                <c:pt idx="36">
                  <c:v>0.79045188380571241</c:v>
                </c:pt>
                <c:pt idx="37">
                  <c:v>0.79045188380571241</c:v>
                </c:pt>
                <c:pt idx="38">
                  <c:v>0.79045188380571241</c:v>
                </c:pt>
                <c:pt idx="39">
                  <c:v>0.79045188380571241</c:v>
                </c:pt>
                <c:pt idx="40">
                  <c:v>0.79045188380571241</c:v>
                </c:pt>
                <c:pt idx="41">
                  <c:v>0.79045188380571241</c:v>
                </c:pt>
                <c:pt idx="42">
                  <c:v>0.79045188380571241</c:v>
                </c:pt>
                <c:pt idx="43">
                  <c:v>0.79045188380571241</c:v>
                </c:pt>
                <c:pt idx="44">
                  <c:v>0.79045188380571241</c:v>
                </c:pt>
                <c:pt idx="45">
                  <c:v>0.79045188380571241</c:v>
                </c:pt>
                <c:pt idx="46">
                  <c:v>0.79045188380571241</c:v>
                </c:pt>
                <c:pt idx="47">
                  <c:v>0.79045188380571241</c:v>
                </c:pt>
                <c:pt idx="48">
                  <c:v>0.79045188380571241</c:v>
                </c:pt>
                <c:pt idx="49" formatCode="General">
                  <c:v>0.79045188380571241</c:v>
                </c:pt>
                <c:pt idx="50">
                  <c:v>0.72964789274373454</c:v>
                </c:pt>
                <c:pt idx="51">
                  <c:v>0.72964789274373454</c:v>
                </c:pt>
                <c:pt idx="52">
                  <c:v>0.72964789274373454</c:v>
                </c:pt>
                <c:pt idx="53">
                  <c:v>0.72964789274373454</c:v>
                </c:pt>
                <c:pt idx="54">
                  <c:v>0.72964789274373454</c:v>
                </c:pt>
                <c:pt idx="55">
                  <c:v>0.72964789274373454</c:v>
                </c:pt>
                <c:pt idx="56">
                  <c:v>0.72964789274373454</c:v>
                </c:pt>
                <c:pt idx="57">
                  <c:v>0.72964789274373454</c:v>
                </c:pt>
                <c:pt idx="58">
                  <c:v>0.72964789274373454</c:v>
                </c:pt>
                <c:pt idx="59">
                  <c:v>0.72964789274373454</c:v>
                </c:pt>
                <c:pt idx="60">
                  <c:v>0.72964789274373454</c:v>
                </c:pt>
                <c:pt idx="61">
                  <c:v>0.72964789274373454</c:v>
                </c:pt>
                <c:pt idx="62">
                  <c:v>0.729647892743734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536-4F83-85EE-342BFF04866D}"/>
            </c:ext>
          </c:extLst>
        </c:ser>
        <c:ser>
          <c:idx val="1"/>
          <c:order val="1"/>
          <c:tx>
            <c:strRef>
              <c:f>作動月LVE!$E$165</c:f>
              <c:strCache>
                <c:ptCount val="1"/>
                <c:pt idx="0">
                  <c:v>QRS/LVEDV &gt;0.66</c:v>
                </c:pt>
              </c:strCache>
            </c:strRef>
          </c:tx>
          <c:spPr>
            <a:ln w="25400">
              <a:solidFill>
                <a:srgbClr val="C0504D"/>
              </a:solidFill>
              <a:prstDash val="solid"/>
            </a:ln>
          </c:spPr>
          <c:marker>
            <c:symbol val="none"/>
          </c:marker>
          <c:xVal>
            <c:numRef>
              <c:f>作動月LVE!$D$166:$D$224</c:f>
              <c:numCache>
                <c:formatCode>General</c:formatCode>
                <c:ptCount val="59"/>
                <c:pt idx="0">
                  <c:v>0</c:v>
                </c:pt>
                <c:pt idx="1">
                  <c:v>2.9333333333333331</c:v>
                </c:pt>
                <c:pt idx="2">
                  <c:v>8.5</c:v>
                </c:pt>
                <c:pt idx="3">
                  <c:v>8.5</c:v>
                </c:pt>
                <c:pt idx="4">
                  <c:v>9.6333333333333329</c:v>
                </c:pt>
                <c:pt idx="5">
                  <c:v>9.8666666666666671</c:v>
                </c:pt>
                <c:pt idx="6">
                  <c:v>9.8666666666666671</c:v>
                </c:pt>
                <c:pt idx="7">
                  <c:v>10.333333333333334</c:v>
                </c:pt>
                <c:pt idx="8">
                  <c:v>12.866666666666667</c:v>
                </c:pt>
                <c:pt idx="9">
                  <c:v>12.866666666666667</c:v>
                </c:pt>
                <c:pt idx="10">
                  <c:v>13.466666666666667</c:v>
                </c:pt>
                <c:pt idx="11">
                  <c:v>15.933333333333334</c:v>
                </c:pt>
                <c:pt idx="12">
                  <c:v>19.066666666666666</c:v>
                </c:pt>
                <c:pt idx="13">
                  <c:v>22.6</c:v>
                </c:pt>
                <c:pt idx="14">
                  <c:v>25.166666666666668</c:v>
                </c:pt>
                <c:pt idx="15">
                  <c:v>25.733333333333334</c:v>
                </c:pt>
                <c:pt idx="16">
                  <c:v>25.8</c:v>
                </c:pt>
                <c:pt idx="17">
                  <c:v>29.666666666666668</c:v>
                </c:pt>
                <c:pt idx="18">
                  <c:v>29.833333333333332</c:v>
                </c:pt>
                <c:pt idx="19">
                  <c:v>30.033333333333335</c:v>
                </c:pt>
                <c:pt idx="20">
                  <c:v>33.333333333333336</c:v>
                </c:pt>
                <c:pt idx="21">
                  <c:v>34.033333333333331</c:v>
                </c:pt>
                <c:pt idx="22">
                  <c:v>35.666666666666664</c:v>
                </c:pt>
                <c:pt idx="23">
                  <c:v>35.9</c:v>
                </c:pt>
                <c:pt idx="24">
                  <c:v>36.833333333333336</c:v>
                </c:pt>
                <c:pt idx="25">
                  <c:v>37.06666666666667</c:v>
                </c:pt>
                <c:pt idx="26">
                  <c:v>40.1</c:v>
                </c:pt>
                <c:pt idx="27">
                  <c:v>41.733333333333334</c:v>
                </c:pt>
                <c:pt idx="28">
                  <c:v>42.033333333333331</c:v>
                </c:pt>
                <c:pt idx="29">
                  <c:v>45.133333333333333</c:v>
                </c:pt>
                <c:pt idx="30">
                  <c:v>45.466666666666669</c:v>
                </c:pt>
                <c:pt idx="31">
                  <c:v>46.06666666666667</c:v>
                </c:pt>
                <c:pt idx="32">
                  <c:v>46.3</c:v>
                </c:pt>
                <c:pt idx="33">
                  <c:v>47.06666666666667</c:v>
                </c:pt>
                <c:pt idx="34">
                  <c:v>53.4</c:v>
                </c:pt>
                <c:pt idx="35">
                  <c:v>56</c:v>
                </c:pt>
                <c:pt idx="36">
                  <c:v>58.766666666666666</c:v>
                </c:pt>
                <c:pt idx="37">
                  <c:v>58.766666666666666</c:v>
                </c:pt>
                <c:pt idx="38">
                  <c:v>59</c:v>
                </c:pt>
                <c:pt idx="39">
                  <c:v>60.56666666666667</c:v>
                </c:pt>
                <c:pt idx="40">
                  <c:v>60.866666666666667</c:v>
                </c:pt>
                <c:pt idx="41">
                  <c:v>65.033333333333331</c:v>
                </c:pt>
                <c:pt idx="42">
                  <c:v>67.033333333333331</c:v>
                </c:pt>
                <c:pt idx="43">
                  <c:v>76.066666666666663</c:v>
                </c:pt>
                <c:pt idx="44">
                  <c:v>77.599999999999994</c:v>
                </c:pt>
                <c:pt idx="45">
                  <c:v>79.599999999999994</c:v>
                </c:pt>
                <c:pt idx="46">
                  <c:v>83.13333333333334</c:v>
                </c:pt>
                <c:pt idx="47">
                  <c:v>88.833333333333329</c:v>
                </c:pt>
                <c:pt idx="48">
                  <c:v>89</c:v>
                </c:pt>
                <c:pt idx="49">
                  <c:v>103.03333333333333</c:v>
                </c:pt>
                <c:pt idx="50">
                  <c:v>107.5</c:v>
                </c:pt>
                <c:pt idx="51">
                  <c:v>111.3</c:v>
                </c:pt>
                <c:pt idx="52">
                  <c:v>115.3</c:v>
                </c:pt>
                <c:pt idx="53">
                  <c:v>119.76666666666667</c:v>
                </c:pt>
                <c:pt idx="54">
                  <c:v>120.23333333333333</c:v>
                </c:pt>
                <c:pt idx="55">
                  <c:v>121.93333333333334</c:v>
                </c:pt>
                <c:pt idx="56">
                  <c:v>131.80000000000001</c:v>
                </c:pt>
                <c:pt idx="57">
                  <c:v>139.73333333333332</c:v>
                </c:pt>
                <c:pt idx="58">
                  <c:v>141.06666666666666</c:v>
                </c:pt>
              </c:numCache>
            </c:numRef>
          </c:xVal>
          <c:yVal>
            <c:numRef>
              <c:f>作動月LVE!$E$166:$E$224</c:f>
              <c:numCache>
                <c:formatCode>0.0000</c:formatCode>
                <c:ptCount val="59"/>
                <c:pt idx="0">
                  <c:v>1</c:v>
                </c:pt>
                <c:pt idx="1">
                  <c:v>1</c:v>
                </c:pt>
                <c:pt idx="2" formatCode="General">
                  <c:v>1</c:v>
                </c:pt>
                <c:pt idx="3">
                  <c:v>0.98113207547169812</c:v>
                </c:pt>
                <c:pt idx="4">
                  <c:v>0.98113207547169812</c:v>
                </c:pt>
                <c:pt idx="5" formatCode="General">
                  <c:v>0.98113207547169812</c:v>
                </c:pt>
                <c:pt idx="6">
                  <c:v>0.96189419163891965</c:v>
                </c:pt>
                <c:pt idx="7">
                  <c:v>0.96189419163891965</c:v>
                </c:pt>
                <c:pt idx="8" formatCode="General">
                  <c:v>0.96189419163891965</c:v>
                </c:pt>
                <c:pt idx="9">
                  <c:v>0.94226369793200293</c:v>
                </c:pt>
                <c:pt idx="10">
                  <c:v>0.94226369793200293</c:v>
                </c:pt>
                <c:pt idx="11">
                  <c:v>0.94226369793200293</c:v>
                </c:pt>
                <c:pt idx="12">
                  <c:v>0.94226369793200293</c:v>
                </c:pt>
                <c:pt idx="13">
                  <c:v>0.94226369793200293</c:v>
                </c:pt>
                <c:pt idx="14">
                  <c:v>0.94226369793200293</c:v>
                </c:pt>
                <c:pt idx="15">
                  <c:v>0.94226369793200293</c:v>
                </c:pt>
                <c:pt idx="16">
                  <c:v>0.94226369793200293</c:v>
                </c:pt>
                <c:pt idx="17">
                  <c:v>0.94226369793200293</c:v>
                </c:pt>
                <c:pt idx="18">
                  <c:v>0.94226369793200293</c:v>
                </c:pt>
                <c:pt idx="19">
                  <c:v>0.94226369793200293</c:v>
                </c:pt>
                <c:pt idx="20">
                  <c:v>0.94226369793200293</c:v>
                </c:pt>
                <c:pt idx="21">
                  <c:v>0.94226369793200293</c:v>
                </c:pt>
                <c:pt idx="22">
                  <c:v>0.94226369793200293</c:v>
                </c:pt>
                <c:pt idx="23">
                  <c:v>0.94226369793200293</c:v>
                </c:pt>
                <c:pt idx="24">
                  <c:v>0.94226369793200293</c:v>
                </c:pt>
                <c:pt idx="25">
                  <c:v>0.94226369793200293</c:v>
                </c:pt>
                <c:pt idx="26">
                  <c:v>0.94226369793200293</c:v>
                </c:pt>
                <c:pt idx="27">
                  <c:v>0.94226369793200293</c:v>
                </c:pt>
                <c:pt idx="28">
                  <c:v>0.94226369793200293</c:v>
                </c:pt>
                <c:pt idx="29">
                  <c:v>0.94226369793200293</c:v>
                </c:pt>
                <c:pt idx="30">
                  <c:v>0.94226369793200293</c:v>
                </c:pt>
                <c:pt idx="31">
                  <c:v>0.94226369793200293</c:v>
                </c:pt>
                <c:pt idx="32">
                  <c:v>0.94226369793200293</c:v>
                </c:pt>
                <c:pt idx="33">
                  <c:v>0.94226369793200293</c:v>
                </c:pt>
                <c:pt idx="34">
                  <c:v>0.94226369793200293</c:v>
                </c:pt>
                <c:pt idx="35">
                  <c:v>0.94226369793200293</c:v>
                </c:pt>
                <c:pt idx="36" formatCode="General">
                  <c:v>0.94226369793200293</c:v>
                </c:pt>
                <c:pt idx="37">
                  <c:v>0.89943352984418468</c:v>
                </c:pt>
                <c:pt idx="38">
                  <c:v>0.89943352984418468</c:v>
                </c:pt>
                <c:pt idx="39">
                  <c:v>0.89943352984418468</c:v>
                </c:pt>
                <c:pt idx="40">
                  <c:v>0.89943352984418468</c:v>
                </c:pt>
                <c:pt idx="41">
                  <c:v>0.89943352984418468</c:v>
                </c:pt>
                <c:pt idx="42">
                  <c:v>0.89943352984418468</c:v>
                </c:pt>
                <c:pt idx="43">
                  <c:v>0.89943352984418468</c:v>
                </c:pt>
                <c:pt idx="44">
                  <c:v>0.89943352984418468</c:v>
                </c:pt>
                <c:pt idx="45">
                  <c:v>0.89943352984418468</c:v>
                </c:pt>
                <c:pt idx="46">
                  <c:v>0.89943352984418468</c:v>
                </c:pt>
                <c:pt idx="47">
                  <c:v>0.89943352984418468</c:v>
                </c:pt>
                <c:pt idx="48">
                  <c:v>0.89943352984418468</c:v>
                </c:pt>
                <c:pt idx="49">
                  <c:v>0.89943352984418468</c:v>
                </c:pt>
                <c:pt idx="50">
                  <c:v>0.89943352984418468</c:v>
                </c:pt>
                <c:pt idx="51">
                  <c:v>0.89943352984418468</c:v>
                </c:pt>
                <c:pt idx="52">
                  <c:v>0.89943352984418468</c:v>
                </c:pt>
                <c:pt idx="53">
                  <c:v>0.89943352984418468</c:v>
                </c:pt>
                <c:pt idx="54">
                  <c:v>0.89943352984418468</c:v>
                </c:pt>
                <c:pt idx="55">
                  <c:v>0.89943352984418468</c:v>
                </c:pt>
                <c:pt idx="56">
                  <c:v>0.89943352984418468</c:v>
                </c:pt>
                <c:pt idx="57">
                  <c:v>0.89943352984418468</c:v>
                </c:pt>
                <c:pt idx="58">
                  <c:v>0.899433529844184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536-4F83-85EE-342BFF0486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24962360"/>
        <c:axId val="1324964000"/>
      </c:scatterChart>
      <c:valAx>
        <c:axId val="13249623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altLang="ja-JP" sz="1100" dirty="0"/>
                  <a:t>Months</a:t>
                </a:r>
                <a:endParaRPr lang="ja-JP" altLang="en-US" sz="110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1324964000"/>
        <c:crosses val="autoZero"/>
        <c:crossBetween val="midCat"/>
        <c:majorUnit val="24"/>
      </c:valAx>
      <c:valAx>
        <c:axId val="1324964000"/>
        <c:scaling>
          <c:orientation val="minMax"/>
          <c:max val="1.100000000000000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altLang="ja-JP" sz="1100" dirty="0"/>
                  <a:t>Percent</a:t>
                </a:r>
                <a:r>
                  <a:rPr lang="en-US" altLang="ja-JP" sz="1100" baseline="0" dirty="0"/>
                  <a:t> survival</a:t>
                </a:r>
                <a:endParaRPr lang="ja-JP" altLang="en-US" sz="1100" dirty="0"/>
              </a:p>
            </c:rich>
          </c:tx>
          <c:overlay val="0"/>
        </c:title>
        <c:numFmt formatCode="0.00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1324962360"/>
        <c:crosses val="autoZero"/>
        <c:crossBetween val="midCat"/>
        <c:majorUnit val="0.2"/>
      </c:valAx>
      <c:spPr>
        <a:noFill/>
      </c:spPr>
    </c:plotArea>
    <c:legend>
      <c:legendPos val="r"/>
      <c:layout>
        <c:manualLayout>
          <c:xMode val="edge"/>
          <c:yMode val="edge"/>
          <c:x val="0.69391768970732148"/>
          <c:y val="0.45367995410467093"/>
          <c:w val="0.26371508317765324"/>
          <c:h val="0.11957435783551706"/>
        </c:manualLayout>
      </c:layout>
      <c:overlay val="0"/>
      <c:txPr>
        <a:bodyPr/>
        <a:lstStyle/>
        <a:p>
          <a:pPr>
            <a:defRPr sz="2400"/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B3EF90-1DC7-4FA6-B42D-10FC64C764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D4EF394-1797-4410-B96B-47589821EE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44EDB1-B6F8-4255-ABBC-E317811E2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337D9A-6A20-4AC5-A20B-1705A8850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FABD16-1966-44DD-AEAA-C46F3FAE1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2692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206E5A-EF9E-4806-9B58-917054D49F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82D276D-7C41-4DA6-B0B0-2E795A132A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E03F6CE-7764-4CCB-B91B-F0456C236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7A6905-07C8-433B-BFA2-19E8DB9C2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605CFA-6D6A-425D-9103-2C33F2653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6455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AFF2AB3-C245-4C44-A5A8-48E0AD10E4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18D9D87-D6AB-4916-912C-88056E76E9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217458-BCFF-4F0A-9171-20CBC8BF1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C8118B-827A-4F0B-9E1D-86296C2D6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3D3F6D-3191-4291-A58C-FF8F755E2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3474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33D4A9-3DF5-48F9-B280-246C39DD7E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9A71956-92B4-4A96-B6EE-997656E192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7D3553-45BB-4A8A-AFAB-64F8964FF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B6721F-8E71-421F-A909-5F587821E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27A96C-444B-4302-9A80-BC36C9CF1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856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11F51E-EE9C-453C-8998-BFE2A04A46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B05ED73-F7D5-489D-9077-ED3927D698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948C10-57C9-409E-98DF-9C98B00A7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AD5214-3577-455C-B478-F25F2DAB9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4A80035-E937-4719-BC0E-CAAFFEC14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9945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6534E6-2820-4ADB-8BCF-D2DCD66AC4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1DE82EF-36A5-4452-80BF-97618B360E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D8A93A5-9C99-4E14-B27E-26B4C81ABB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E163F42-E650-4075-810D-658EA2BC3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A48E372-47B0-4C86-82B6-5A8B21BBC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8564A0-B183-43A7-8B92-520BD1C0F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717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B26353-25C4-43FE-AF86-FBD3210A9A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CDBABB-233E-40B9-94E4-44FB92EF7C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F01FBA3-BEAA-4D94-A23C-D509E7D782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D3C3D35-1229-41F9-B6EF-1E6BA0EE5A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720284D-5E09-4768-9172-9520450BBC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49A285E-BFFA-4378-9E3B-C2D78D61D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7881425-C712-46FF-9257-9F167590A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D1E2A11-F00D-4B53-83F0-644469424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6578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00E2D9-DBF3-49EC-A0DA-FFE3428520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4881C46-87D5-4B60-8CA3-C881505F8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6119E6B-3785-40AA-B40C-32F4DCC636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58CC2E5-EF26-4519-930E-7DD5F220E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97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0F845A5-CA74-4964-9581-EC26CED5E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2481FBB-BC1B-4605-BA07-42C3B40F7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1EAF2DC-BBFB-4A69-AE48-73639315B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777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08E153-9780-47A7-BA45-CD3A45DE1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044F476-2B05-48A3-8023-9B3B193160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6E908E5-967C-4728-B9C6-C87E3DD779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C4F59B-E72B-446E-8947-651854638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C2344A4-19A9-48ED-AA4A-3A15CE098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10766B0-00FA-44AA-A1B7-596B960F3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27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D4C7F6-8AA1-4461-8D9B-2673337D91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B32CF77-267D-4AF9-B6D4-797334CC14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274E87C-F1AC-482A-861D-03D775BD18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1859B70-AEE0-4185-9ACA-9B9ADCBCE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EA6FD4E-BF01-445E-BBEC-EE14E86A6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8FD1890-677F-4780-8C3A-14F28A831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652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41DCD4E-4089-41C0-A40C-D4D08CCB5B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733116C-BA18-463C-800C-65A86C6C64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8D633B-AF18-4D36-A2D2-A7B7BC0729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9A547C-7CEA-4B10-BFEA-5DB4C6A8EF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C9CE96-7899-4357-82A4-5235D21158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404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D3300751-8258-4D50-9A7B-D4FC6BB790A1}"/>
              </a:ext>
            </a:extLst>
          </p:cNvPr>
          <p:cNvGrpSpPr/>
          <p:nvPr/>
        </p:nvGrpSpPr>
        <p:grpSpPr>
          <a:xfrm>
            <a:off x="1024517" y="246509"/>
            <a:ext cx="9858340" cy="6364982"/>
            <a:chOff x="734060" y="348210"/>
            <a:chExt cx="9858340" cy="6364982"/>
          </a:xfrm>
        </p:grpSpPr>
        <p:graphicFrame>
          <p:nvGraphicFramePr>
            <p:cNvPr id="9" name="グラフ 8">
              <a:extLst>
                <a:ext uri="{FF2B5EF4-FFF2-40B4-BE49-F238E27FC236}">
                  <a16:creationId xmlns:a16="http://schemas.microsoft.com/office/drawing/2014/main" id="{79CEAADC-81BA-49EF-9B38-13369C8E95E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1546676"/>
                </p:ext>
              </p:extLst>
            </p:nvPr>
          </p:nvGraphicFramePr>
          <p:xfrm>
            <a:off x="1599600" y="348210"/>
            <a:ext cx="8992800" cy="5403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06C833FD-B80C-4094-BFC1-6267659E41A9}"/>
                </a:ext>
              </a:extLst>
            </p:cNvPr>
            <p:cNvGrpSpPr/>
            <p:nvPr/>
          </p:nvGrpSpPr>
          <p:grpSpPr>
            <a:xfrm>
              <a:off x="734060" y="5239583"/>
              <a:ext cx="7562847" cy="1473609"/>
              <a:chOff x="734060" y="5239583"/>
              <a:chExt cx="7562847" cy="1473609"/>
            </a:xfrm>
          </p:grpSpPr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5E7D29D0-6629-4F0A-A4B9-292818617ABF}"/>
                  </a:ext>
                </a:extLst>
              </p:cNvPr>
              <p:cNvSpPr txBox="1"/>
              <p:nvPr/>
            </p:nvSpPr>
            <p:spPr>
              <a:xfrm>
                <a:off x="734060" y="5239583"/>
                <a:ext cx="1894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dirty="0"/>
                  <a:t>Number at risk</a:t>
                </a:r>
                <a:endParaRPr kumimoji="1" lang="ja-JP" altLang="en-US" sz="1600" dirty="0"/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99C2C739-7490-40BD-9373-DA0C9A07BE5C}"/>
                  </a:ext>
                </a:extLst>
              </p:cNvPr>
              <p:cNvSpPr txBox="1"/>
              <p:nvPr/>
            </p:nvSpPr>
            <p:spPr>
              <a:xfrm>
                <a:off x="1130300" y="5547360"/>
                <a:ext cx="1102360" cy="1165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kumimoji="1" lang="en-US" altLang="ja-JP" sz="1600" dirty="0"/>
                  <a:t>Class I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Class </a:t>
                </a:r>
                <a:r>
                  <a:rPr lang="en-US" altLang="ja-JP" sz="1600" dirty="0" err="1"/>
                  <a:t>IIa</a:t>
                </a:r>
                <a:endParaRPr lang="en-US" altLang="ja-JP" sz="1600" dirty="0"/>
              </a:p>
              <a:p>
                <a:pPr>
                  <a:lnSpc>
                    <a:spcPct val="150000"/>
                  </a:lnSpc>
                </a:pPr>
                <a:r>
                  <a:rPr kumimoji="1" lang="en-US" altLang="ja-JP" sz="1600" dirty="0"/>
                  <a:t>Class IIb</a:t>
                </a:r>
                <a:endParaRPr kumimoji="1" lang="ja-JP" altLang="en-US" sz="1600" dirty="0"/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3A2A85F4-D218-4748-9DB7-651758DC3FF1}"/>
                  </a:ext>
                </a:extLst>
              </p:cNvPr>
              <p:cNvSpPr txBox="1"/>
              <p:nvPr/>
            </p:nvSpPr>
            <p:spPr>
              <a:xfrm>
                <a:off x="2232660" y="5547360"/>
                <a:ext cx="492760" cy="1165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60</a:t>
                </a:r>
                <a:endParaRPr kumimoji="1" lang="en-US" altLang="ja-JP" sz="1600" dirty="0"/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30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24</a:t>
                </a:r>
                <a:endParaRPr kumimoji="1" lang="ja-JP" altLang="en-US" sz="1600" dirty="0"/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AFB86E82-BFFB-43FB-9476-18FC354FFD3C}"/>
                  </a:ext>
                </a:extLst>
              </p:cNvPr>
              <p:cNvSpPr txBox="1"/>
              <p:nvPr/>
            </p:nvSpPr>
            <p:spPr>
              <a:xfrm>
                <a:off x="3129280" y="5547360"/>
                <a:ext cx="492760" cy="1165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kumimoji="1" lang="en-US" altLang="ja-JP" sz="1600" dirty="0"/>
                  <a:t>48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22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21</a:t>
                </a:r>
                <a:endParaRPr kumimoji="1" lang="ja-JP" altLang="en-US" sz="1600" dirty="0"/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C8509A27-B1DD-4FE9-AAE5-1C9EE8D63C26}"/>
                  </a:ext>
                </a:extLst>
              </p:cNvPr>
              <p:cNvSpPr txBox="1"/>
              <p:nvPr/>
            </p:nvSpPr>
            <p:spPr>
              <a:xfrm>
                <a:off x="4083050" y="5547360"/>
                <a:ext cx="492760" cy="1165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kumimoji="1" lang="en-US" altLang="ja-JP" sz="1600" dirty="0"/>
                  <a:t>33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11</a:t>
                </a:r>
              </a:p>
              <a:p>
                <a:pPr>
                  <a:lnSpc>
                    <a:spcPct val="150000"/>
                  </a:lnSpc>
                </a:pPr>
                <a:r>
                  <a:rPr kumimoji="1" lang="en-US" altLang="ja-JP" sz="1600" dirty="0"/>
                  <a:t>9</a:t>
                </a:r>
                <a:endParaRPr kumimoji="1" lang="ja-JP" altLang="en-US" sz="1600" dirty="0"/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41E8E8BE-E67B-4C64-8F23-2434F5AF4C79}"/>
                  </a:ext>
                </a:extLst>
              </p:cNvPr>
              <p:cNvSpPr txBox="1"/>
              <p:nvPr/>
            </p:nvSpPr>
            <p:spPr>
              <a:xfrm>
                <a:off x="4996180" y="5547360"/>
                <a:ext cx="492760" cy="1165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23</a:t>
                </a:r>
                <a:endParaRPr kumimoji="1" lang="en-US" altLang="ja-JP" sz="1600" dirty="0"/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5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6</a:t>
                </a:r>
                <a:endParaRPr kumimoji="1" lang="ja-JP" altLang="en-US" sz="1600" dirty="0"/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73355605-8A0D-41AF-9594-0AE4C9B902F3}"/>
                  </a:ext>
                </a:extLst>
              </p:cNvPr>
              <p:cNvSpPr txBox="1"/>
              <p:nvPr/>
            </p:nvSpPr>
            <p:spPr>
              <a:xfrm>
                <a:off x="5932169" y="5547360"/>
                <a:ext cx="492760" cy="1165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kumimoji="1" lang="en-US" altLang="ja-JP" sz="1600" dirty="0"/>
                  <a:t>1</a:t>
                </a:r>
                <a:r>
                  <a:rPr lang="en-US" altLang="ja-JP" sz="1600" dirty="0"/>
                  <a:t>6</a:t>
                </a:r>
                <a:endParaRPr kumimoji="1" lang="en-US" altLang="ja-JP" sz="1600" dirty="0"/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3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2</a:t>
                </a:r>
                <a:endParaRPr kumimoji="1" lang="ja-JP" altLang="en-US" sz="1600" dirty="0"/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5634AEB5-6260-475D-B88C-DC2F5A17279F}"/>
                  </a:ext>
                </a:extLst>
              </p:cNvPr>
              <p:cNvSpPr txBox="1"/>
              <p:nvPr/>
            </p:nvSpPr>
            <p:spPr>
              <a:xfrm>
                <a:off x="6868158" y="5547360"/>
                <a:ext cx="492760" cy="1165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8</a:t>
                </a:r>
                <a:endParaRPr kumimoji="1" lang="en-US" altLang="ja-JP" sz="1600" dirty="0"/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2</a:t>
                </a:r>
              </a:p>
              <a:p>
                <a:pPr>
                  <a:lnSpc>
                    <a:spcPct val="150000"/>
                  </a:lnSpc>
                </a:pPr>
                <a:r>
                  <a:rPr kumimoji="1" lang="en-US" altLang="ja-JP" sz="1600" dirty="0"/>
                  <a:t>0</a:t>
                </a:r>
                <a:endParaRPr kumimoji="1" lang="ja-JP" altLang="en-US" sz="1600" dirty="0"/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2212BE94-0C7C-4BCB-9CC6-25B800C09228}"/>
                  </a:ext>
                </a:extLst>
              </p:cNvPr>
              <p:cNvSpPr txBox="1"/>
              <p:nvPr/>
            </p:nvSpPr>
            <p:spPr>
              <a:xfrm>
                <a:off x="7804147" y="5547360"/>
                <a:ext cx="492760" cy="1165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0</a:t>
                </a:r>
                <a:endParaRPr kumimoji="1" lang="en-US" altLang="ja-JP" sz="1600" dirty="0"/>
              </a:p>
              <a:p>
                <a:pPr>
                  <a:lnSpc>
                    <a:spcPct val="150000"/>
                  </a:lnSpc>
                </a:pPr>
                <a:r>
                  <a:rPr lang="en-US" altLang="ja-JP" sz="1600" dirty="0"/>
                  <a:t>0</a:t>
                </a:r>
              </a:p>
              <a:p>
                <a:pPr>
                  <a:lnSpc>
                    <a:spcPct val="150000"/>
                  </a:lnSpc>
                </a:pPr>
                <a:r>
                  <a:rPr kumimoji="1" lang="en-US" altLang="ja-JP" sz="1600" dirty="0"/>
                  <a:t>0</a:t>
                </a:r>
                <a:endParaRPr kumimoji="1" lang="ja-JP" altLang="en-US" sz="1600" dirty="0"/>
              </a:p>
            </p:txBody>
          </p:sp>
        </p:grp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7BD28CA-BD8F-4293-B06E-3C156E54F12E}"/>
              </a:ext>
            </a:extLst>
          </p:cNvPr>
          <p:cNvSpPr txBox="1"/>
          <p:nvPr/>
        </p:nvSpPr>
        <p:spPr>
          <a:xfrm>
            <a:off x="2938215" y="3825859"/>
            <a:ext cx="1534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p=0.060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5BEDA5F-BEEB-4F34-ADE3-33ACBDBE7CAB}"/>
              </a:ext>
            </a:extLst>
          </p:cNvPr>
          <p:cNvSpPr txBox="1"/>
          <p:nvPr/>
        </p:nvSpPr>
        <p:spPr>
          <a:xfrm>
            <a:off x="2919357" y="4179802"/>
            <a:ext cx="76905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HR : 2.46 (Class I vs. Class </a:t>
            </a:r>
            <a:r>
              <a:rPr lang="en-US" altLang="ja-JP" dirty="0" err="1"/>
              <a:t>IIa</a:t>
            </a:r>
            <a:r>
              <a:rPr lang="en-US" altLang="ja-JP" dirty="0"/>
              <a:t>), 1.84 (Class I vs. Class IIb)</a:t>
            </a:r>
          </a:p>
          <a:p>
            <a:r>
              <a:rPr lang="en-US" altLang="ja-JP" dirty="0"/>
              <a:t>95%CI: 0.66-9.16 (Class I vs. Class </a:t>
            </a:r>
            <a:r>
              <a:rPr lang="en-US" altLang="ja-JP" dirty="0" err="1"/>
              <a:t>IIa</a:t>
            </a:r>
            <a:r>
              <a:rPr lang="en-US" altLang="ja-JP" dirty="0"/>
              <a:t>), 0.42-7.93 (Class I vs. Class IIb)</a:t>
            </a:r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76FA3C3-017C-46BF-BCC9-4530E0A1125E}"/>
              </a:ext>
            </a:extLst>
          </p:cNvPr>
          <p:cNvSpPr txBox="1"/>
          <p:nvPr/>
        </p:nvSpPr>
        <p:spPr>
          <a:xfrm>
            <a:off x="297635" y="359197"/>
            <a:ext cx="1044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A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2CBB37A-8648-4A0D-A34A-775BBA82FC2C}"/>
              </a:ext>
            </a:extLst>
          </p:cNvPr>
          <p:cNvSpPr txBox="1"/>
          <p:nvPr/>
        </p:nvSpPr>
        <p:spPr>
          <a:xfrm>
            <a:off x="8848426" y="2859345"/>
            <a:ext cx="1453517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Class I</a:t>
            </a:r>
            <a:r>
              <a:rPr lang="ja-JP" altLang="en-US" dirty="0"/>
              <a:t>  </a:t>
            </a:r>
            <a:endParaRPr lang="en-US" altLang="ja-JP" dirty="0"/>
          </a:p>
          <a:p>
            <a:r>
              <a:rPr kumimoji="1" lang="en-US" altLang="ja-JP" dirty="0"/>
              <a:t>Class </a:t>
            </a:r>
            <a:r>
              <a:rPr kumimoji="1" lang="en-US" altLang="ja-JP" dirty="0" err="1"/>
              <a:t>IIa</a:t>
            </a:r>
            <a:endParaRPr kumimoji="1" lang="en-US" altLang="ja-JP" dirty="0"/>
          </a:p>
          <a:p>
            <a:r>
              <a:rPr lang="en-US" altLang="ja-JP" dirty="0"/>
              <a:t>Class IIb</a:t>
            </a:r>
          </a:p>
        </p:txBody>
      </p: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30CE7FB2-B6A6-4AE3-B391-392C113390C7}"/>
              </a:ext>
            </a:extLst>
          </p:cNvPr>
          <p:cNvGrpSpPr/>
          <p:nvPr/>
        </p:nvGrpSpPr>
        <p:grpSpPr>
          <a:xfrm>
            <a:off x="7408409" y="2852041"/>
            <a:ext cx="1372390" cy="923330"/>
            <a:chOff x="10376007" y="2809668"/>
            <a:chExt cx="1372390" cy="923330"/>
          </a:xfrm>
          <a:solidFill>
            <a:schemeClr val="bg1"/>
          </a:solidFill>
        </p:grpSpPr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31C23F21-6734-443E-BE86-EC36D5ED467F}"/>
                </a:ext>
              </a:extLst>
            </p:cNvPr>
            <p:cNvSpPr txBox="1"/>
            <p:nvPr/>
          </p:nvSpPr>
          <p:spPr>
            <a:xfrm>
              <a:off x="10654828" y="2809668"/>
              <a:ext cx="1093569" cy="923330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Class I</a:t>
              </a:r>
            </a:p>
            <a:p>
              <a:r>
                <a:rPr kumimoji="1" lang="en-US" altLang="ja-JP" dirty="0"/>
                <a:t>Class </a:t>
              </a:r>
              <a:r>
                <a:rPr kumimoji="1" lang="en-US" altLang="ja-JP" dirty="0" err="1"/>
                <a:t>IIa</a:t>
              </a:r>
              <a:endParaRPr kumimoji="1" lang="en-US" altLang="ja-JP" dirty="0"/>
            </a:p>
            <a:p>
              <a:r>
                <a:rPr lang="en-US" altLang="ja-JP" dirty="0"/>
                <a:t>Class IIb</a:t>
              </a:r>
              <a:endParaRPr kumimoji="1" lang="ja-JP" altLang="en-US" dirty="0"/>
            </a:p>
          </p:txBody>
        </p: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C75D77AE-F4EB-4D5D-B02D-F977FE9B17D9}"/>
                </a:ext>
              </a:extLst>
            </p:cNvPr>
            <p:cNvCxnSpPr/>
            <p:nvPr/>
          </p:nvCxnSpPr>
          <p:spPr>
            <a:xfrm>
              <a:off x="10376007" y="2977337"/>
              <a:ext cx="255215" cy="0"/>
            </a:xfrm>
            <a:prstGeom prst="line">
              <a:avLst/>
            </a:prstGeom>
            <a:grpFill/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8FA3B264-8D42-4B4A-A762-C101D3876BD0}"/>
                </a:ext>
              </a:extLst>
            </p:cNvPr>
            <p:cNvCxnSpPr/>
            <p:nvPr/>
          </p:nvCxnSpPr>
          <p:spPr>
            <a:xfrm>
              <a:off x="10383267" y="3245849"/>
              <a:ext cx="255215" cy="0"/>
            </a:xfrm>
            <a:prstGeom prst="line">
              <a:avLst/>
            </a:prstGeom>
            <a:grpFill/>
            <a:ln w="28575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EBCFFE58-4BBC-4679-AB6E-0B5024FD3D5E}"/>
                </a:ext>
              </a:extLst>
            </p:cNvPr>
            <p:cNvCxnSpPr/>
            <p:nvPr/>
          </p:nvCxnSpPr>
          <p:spPr>
            <a:xfrm>
              <a:off x="10393055" y="3557905"/>
              <a:ext cx="255215" cy="0"/>
            </a:xfrm>
            <a:prstGeom prst="line">
              <a:avLst/>
            </a:prstGeom>
            <a:grpFill/>
            <a:ln w="28575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FA326526-E842-4B71-8B83-D2B716970EF5}"/>
              </a:ext>
            </a:extLst>
          </p:cNvPr>
          <p:cNvSpPr/>
          <p:nvPr/>
        </p:nvSpPr>
        <p:spPr>
          <a:xfrm>
            <a:off x="8915123" y="2773506"/>
            <a:ext cx="1093568" cy="914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4674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EB051255-975B-46B9-997C-AF379F9DF5D7}"/>
              </a:ext>
            </a:extLst>
          </p:cNvPr>
          <p:cNvGraphicFramePr>
            <a:graphicFrameLocks/>
          </p:cNvGraphicFramePr>
          <p:nvPr/>
        </p:nvGraphicFramePr>
        <p:xfrm>
          <a:off x="2273935" y="752475"/>
          <a:ext cx="7827010" cy="5353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C107DF3-78DD-42D5-A914-DDFF0BF628DC}"/>
              </a:ext>
            </a:extLst>
          </p:cNvPr>
          <p:cNvSpPr txBox="1"/>
          <p:nvPr/>
        </p:nvSpPr>
        <p:spPr>
          <a:xfrm>
            <a:off x="4143375" y="3238500"/>
            <a:ext cx="475234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rgbClr val="FF0000"/>
                </a:solidFill>
              </a:rPr>
              <a:t>Best c</a:t>
            </a:r>
            <a:r>
              <a:rPr kumimoji="1" lang="en-US" altLang="ja-JP" b="1" dirty="0">
                <a:solidFill>
                  <a:srgbClr val="FF0000"/>
                </a:solidFill>
              </a:rPr>
              <a:t>ut-off Point</a:t>
            </a:r>
          </a:p>
          <a:p>
            <a:pPr algn="ctr"/>
            <a:r>
              <a:rPr kumimoji="1" lang="en-US" altLang="ja-JP" b="1" dirty="0" err="1">
                <a:solidFill>
                  <a:srgbClr val="FF0000"/>
                </a:solidFill>
              </a:rPr>
              <a:t>QRSd</a:t>
            </a:r>
            <a:r>
              <a:rPr kumimoji="1" lang="en-US" altLang="ja-JP" b="1" dirty="0">
                <a:solidFill>
                  <a:srgbClr val="FF0000"/>
                </a:solidFill>
              </a:rPr>
              <a:t>/LVEDV=0.66 </a:t>
            </a:r>
          </a:p>
          <a:p>
            <a:pPr algn="ctr"/>
            <a:r>
              <a:rPr kumimoji="1" lang="en-US" altLang="ja-JP" b="1" dirty="0">
                <a:solidFill>
                  <a:srgbClr val="FF0000"/>
                </a:solidFill>
              </a:rPr>
              <a:t>(Odds</a:t>
            </a:r>
            <a:r>
              <a:rPr lang="ja-JP" altLang="en-US" b="1" dirty="0">
                <a:solidFill>
                  <a:srgbClr val="FF0000"/>
                </a:solidFill>
              </a:rPr>
              <a:t> </a:t>
            </a:r>
            <a:r>
              <a:rPr lang="en-US" altLang="ja-JP" b="1" dirty="0">
                <a:solidFill>
                  <a:srgbClr val="FF0000"/>
                </a:solidFill>
              </a:rPr>
              <a:t>ratio: 3.0441)</a:t>
            </a:r>
          </a:p>
          <a:p>
            <a:pPr algn="ctr"/>
            <a:r>
              <a:rPr kumimoji="1" lang="en-US" altLang="ja-JP" b="1" dirty="0">
                <a:solidFill>
                  <a:srgbClr val="FF0000"/>
                </a:solidFill>
              </a:rPr>
              <a:t>(AUC</a:t>
            </a:r>
            <a:r>
              <a:rPr lang="en-US" altLang="ja-JP" b="1" dirty="0">
                <a:solidFill>
                  <a:srgbClr val="FF0000"/>
                </a:solidFill>
              </a:rPr>
              <a:t>: 0.62)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  <p:sp>
        <p:nvSpPr>
          <p:cNvPr id="7" name="楕円 6">
            <a:extLst>
              <a:ext uri="{FF2B5EF4-FFF2-40B4-BE49-F238E27FC236}">
                <a16:creationId xmlns:a16="http://schemas.microsoft.com/office/drawing/2014/main" id="{CBD60060-D3AC-4B2E-B50B-56B279611D75}"/>
              </a:ext>
            </a:extLst>
          </p:cNvPr>
          <p:cNvSpPr/>
          <p:nvPr/>
        </p:nvSpPr>
        <p:spPr>
          <a:xfrm>
            <a:off x="5010149" y="2752725"/>
            <a:ext cx="133351" cy="14287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6900E7B1-ED9D-4B29-82C9-CC2EC1AEE342}"/>
              </a:ext>
            </a:extLst>
          </p:cNvPr>
          <p:cNvCxnSpPr>
            <a:cxnSpLocks/>
          </p:cNvCxnSpPr>
          <p:nvPr/>
        </p:nvCxnSpPr>
        <p:spPr>
          <a:xfrm flipH="1" flipV="1">
            <a:off x="5143500" y="2933700"/>
            <a:ext cx="257175" cy="3048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8970258-7E4F-4265-A0BD-09CC6CC2B69D}"/>
              </a:ext>
            </a:extLst>
          </p:cNvPr>
          <p:cNvSpPr txBox="1"/>
          <p:nvPr/>
        </p:nvSpPr>
        <p:spPr>
          <a:xfrm>
            <a:off x="621438" y="383143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94582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74190B27-E23B-4A11-995B-A0179897E5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3777019"/>
              </p:ext>
            </p:extLst>
          </p:nvPr>
        </p:nvGraphicFramePr>
        <p:xfrm>
          <a:off x="1928529" y="124520"/>
          <a:ext cx="8992800" cy="540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FC05BEA-B2A0-4F8D-80C0-2C1E268225D9}"/>
              </a:ext>
            </a:extLst>
          </p:cNvPr>
          <p:cNvSpPr txBox="1"/>
          <p:nvPr/>
        </p:nvSpPr>
        <p:spPr>
          <a:xfrm>
            <a:off x="3216909" y="3228945"/>
            <a:ext cx="1534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p=0.079</a:t>
            </a:r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3F016C1-F753-45E2-9711-FA0782415F30}"/>
              </a:ext>
            </a:extLst>
          </p:cNvPr>
          <p:cNvSpPr txBox="1"/>
          <p:nvPr/>
        </p:nvSpPr>
        <p:spPr>
          <a:xfrm>
            <a:off x="3216909" y="3629055"/>
            <a:ext cx="38125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HR: 0.31</a:t>
            </a:r>
          </a:p>
          <a:p>
            <a:r>
              <a:rPr kumimoji="1" lang="en-US" altLang="ja-JP" dirty="0"/>
              <a:t>95% </a:t>
            </a:r>
            <a:r>
              <a:rPr lang="en-US" altLang="ja-JP" dirty="0"/>
              <a:t>CI: 0.08-1.15</a:t>
            </a:r>
            <a:endParaRPr kumimoji="1" lang="ja-JP" altLang="en-US" dirty="0"/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90451BE3-C325-48D2-B0B9-DCA19E61D170}"/>
              </a:ext>
            </a:extLst>
          </p:cNvPr>
          <p:cNvGrpSpPr/>
          <p:nvPr/>
        </p:nvGrpSpPr>
        <p:grpSpPr>
          <a:xfrm>
            <a:off x="361949" y="5358843"/>
            <a:ext cx="8296907" cy="1135054"/>
            <a:chOff x="0" y="5208806"/>
            <a:chExt cx="8296907" cy="1135054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40A043CA-F579-4893-A607-2D9D74F85872}"/>
                </a:ext>
              </a:extLst>
            </p:cNvPr>
            <p:cNvSpPr txBox="1"/>
            <p:nvPr/>
          </p:nvSpPr>
          <p:spPr>
            <a:xfrm>
              <a:off x="168910" y="5208806"/>
              <a:ext cx="1894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/>
                <a:t>Number at risk</a:t>
              </a:r>
              <a:endParaRPr kumimoji="1" lang="ja-JP" altLang="en-US" sz="1600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444844D-A312-457A-93D5-4398684ED7A5}"/>
                </a:ext>
              </a:extLst>
            </p:cNvPr>
            <p:cNvSpPr txBox="1"/>
            <p:nvPr/>
          </p:nvSpPr>
          <p:spPr>
            <a:xfrm>
              <a:off x="0" y="5547360"/>
              <a:ext cx="2232660" cy="7913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ja-JP" sz="1600" dirty="0"/>
                <a:t>QRS/LVEDV &lt;</a:t>
              </a:r>
              <a:r>
                <a:rPr lang="ja-JP" altLang="en-US" sz="1600" dirty="0"/>
                <a:t> </a:t>
              </a:r>
              <a:r>
                <a:rPr lang="en-US" altLang="ja-JP" sz="1600" dirty="0"/>
                <a:t>0.67</a:t>
              </a:r>
              <a:endParaRPr kumimoji="1" lang="en-US" altLang="ja-JP" sz="1600" dirty="0"/>
            </a:p>
            <a:p>
              <a:pPr>
                <a:lnSpc>
                  <a:spcPct val="150000"/>
                </a:lnSpc>
              </a:pPr>
              <a:r>
                <a:rPr lang="en-US" altLang="ja-JP" sz="1600" dirty="0"/>
                <a:t>QRS/LVEDV </a:t>
              </a:r>
              <a:r>
                <a:rPr lang="ja-JP" altLang="en-US" sz="1600" dirty="0"/>
                <a:t>≥ </a:t>
              </a:r>
              <a:r>
                <a:rPr lang="en-US" altLang="ja-JP" sz="1600" dirty="0"/>
                <a:t>0.67</a:t>
              </a:r>
              <a:endParaRPr kumimoji="1" lang="en-US" altLang="ja-JP" sz="160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AD58182D-DBE6-4FB2-A618-52155DF1CFCD}"/>
                </a:ext>
              </a:extLst>
            </p:cNvPr>
            <p:cNvSpPr txBox="1"/>
            <p:nvPr/>
          </p:nvSpPr>
          <p:spPr>
            <a:xfrm>
              <a:off x="2232660" y="5547360"/>
              <a:ext cx="492760" cy="7965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kumimoji="1" lang="en-US" altLang="ja-JP" sz="1600" dirty="0"/>
                <a:t>52</a:t>
              </a:r>
            </a:p>
            <a:p>
              <a:pPr>
                <a:lnSpc>
                  <a:spcPct val="150000"/>
                </a:lnSpc>
              </a:pPr>
              <a:r>
                <a:rPr lang="en-US" altLang="ja-JP" sz="1600" dirty="0"/>
                <a:t>54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32FAC1F0-4664-443D-9E1D-BAD37C3A7D1A}"/>
                </a:ext>
              </a:extLst>
            </p:cNvPr>
            <p:cNvSpPr txBox="1"/>
            <p:nvPr/>
          </p:nvSpPr>
          <p:spPr>
            <a:xfrm>
              <a:off x="3129280" y="5547360"/>
              <a:ext cx="492760" cy="7965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kumimoji="1" lang="en-US" altLang="ja-JP" sz="1600" dirty="0"/>
                <a:t>40</a:t>
              </a:r>
            </a:p>
            <a:p>
              <a:pPr>
                <a:lnSpc>
                  <a:spcPct val="150000"/>
                </a:lnSpc>
              </a:pPr>
              <a:r>
                <a:rPr lang="en-US" altLang="ja-JP" sz="1600" dirty="0"/>
                <a:t>44</a:t>
              </a: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1AAD6AB6-A2A8-4934-935D-B84AF30BD116}"/>
                </a:ext>
              </a:extLst>
            </p:cNvPr>
            <p:cNvSpPr txBox="1"/>
            <p:nvPr/>
          </p:nvSpPr>
          <p:spPr>
            <a:xfrm>
              <a:off x="4083050" y="5547360"/>
              <a:ext cx="492760" cy="7965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kumimoji="1" lang="en-US" altLang="ja-JP" sz="1600" dirty="0"/>
                <a:t>2</a:t>
              </a:r>
              <a:r>
                <a:rPr lang="en-US" altLang="ja-JP" sz="1600" dirty="0"/>
                <a:t>5</a:t>
              </a:r>
              <a:endParaRPr kumimoji="1" lang="en-US" altLang="ja-JP" sz="1600" dirty="0"/>
            </a:p>
            <a:p>
              <a:pPr>
                <a:lnSpc>
                  <a:spcPct val="150000"/>
                </a:lnSpc>
              </a:pPr>
              <a:r>
                <a:rPr lang="en-US" altLang="ja-JP" sz="1600" dirty="0"/>
                <a:t>24</a:t>
              </a: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B0B357FA-F5E0-4B8E-95BA-4D6151E04EA5}"/>
                </a:ext>
              </a:extLst>
            </p:cNvPr>
            <p:cNvSpPr txBox="1"/>
            <p:nvPr/>
          </p:nvSpPr>
          <p:spPr>
            <a:xfrm>
              <a:off x="4996180" y="5547360"/>
              <a:ext cx="492760" cy="7965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kumimoji="1" lang="en-US" altLang="ja-JP" sz="1600" dirty="0"/>
                <a:t>16</a:t>
              </a:r>
            </a:p>
            <a:p>
              <a:pPr>
                <a:lnSpc>
                  <a:spcPct val="150000"/>
                </a:lnSpc>
              </a:pPr>
              <a:r>
                <a:rPr lang="en-US" altLang="ja-JP" sz="1600" dirty="0"/>
                <a:t>16</a:t>
              </a: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5A94CE1B-4A01-4241-B71C-D657529ECA2C}"/>
                </a:ext>
              </a:extLst>
            </p:cNvPr>
            <p:cNvSpPr txBox="1"/>
            <p:nvPr/>
          </p:nvSpPr>
          <p:spPr>
            <a:xfrm>
              <a:off x="5932169" y="5547360"/>
              <a:ext cx="492760" cy="7965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kumimoji="1" lang="en-US" altLang="ja-JP" sz="1600" dirty="0"/>
                <a:t>1</a:t>
              </a:r>
              <a:r>
                <a:rPr lang="en-US" altLang="ja-JP" sz="1600" dirty="0"/>
                <a:t>1</a:t>
              </a:r>
              <a:endParaRPr kumimoji="1" lang="en-US" altLang="ja-JP" sz="1600" dirty="0"/>
            </a:p>
            <a:p>
              <a:pPr>
                <a:lnSpc>
                  <a:spcPct val="150000"/>
                </a:lnSpc>
              </a:pPr>
              <a:r>
                <a:rPr lang="en-US" altLang="ja-JP" sz="1600" dirty="0"/>
                <a:t>10</a:t>
              </a: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DEE3FD3D-CFBD-4244-BBA9-5CDAE236CBC7}"/>
                </a:ext>
              </a:extLst>
            </p:cNvPr>
            <p:cNvSpPr txBox="1"/>
            <p:nvPr/>
          </p:nvSpPr>
          <p:spPr>
            <a:xfrm>
              <a:off x="6868158" y="5547360"/>
              <a:ext cx="492760" cy="7965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kumimoji="1" lang="en-US" altLang="ja-JP" sz="1600" dirty="0"/>
                <a:t>4</a:t>
              </a:r>
            </a:p>
            <a:p>
              <a:pPr>
                <a:lnSpc>
                  <a:spcPct val="150000"/>
                </a:lnSpc>
              </a:pPr>
              <a:r>
                <a:rPr lang="en-US" altLang="ja-JP" sz="1600" dirty="0"/>
                <a:t>5</a:t>
              </a: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72E8A8E5-0836-4284-A05A-41B49C601351}"/>
                </a:ext>
              </a:extLst>
            </p:cNvPr>
            <p:cNvSpPr txBox="1"/>
            <p:nvPr/>
          </p:nvSpPr>
          <p:spPr>
            <a:xfrm>
              <a:off x="7804147" y="5547360"/>
              <a:ext cx="492760" cy="7965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ja-JP" sz="1600" dirty="0"/>
                <a:t>0</a:t>
              </a:r>
              <a:endParaRPr kumimoji="1" lang="en-US" altLang="ja-JP" sz="1600" dirty="0"/>
            </a:p>
            <a:p>
              <a:pPr>
                <a:lnSpc>
                  <a:spcPct val="150000"/>
                </a:lnSpc>
              </a:pPr>
              <a:r>
                <a:rPr lang="en-US" altLang="ja-JP" sz="1600" dirty="0"/>
                <a:t>0</a:t>
              </a: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EBD51254-3270-40F9-BC0F-672A4266D5A8}"/>
              </a:ext>
            </a:extLst>
          </p:cNvPr>
          <p:cNvGrpSpPr/>
          <p:nvPr/>
        </p:nvGrpSpPr>
        <p:grpSpPr>
          <a:xfrm>
            <a:off x="7909322" y="2673328"/>
            <a:ext cx="3012007" cy="646331"/>
            <a:chOff x="7195808" y="3429000"/>
            <a:chExt cx="3012007" cy="646331"/>
          </a:xfrm>
        </p:grpSpPr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743169F7-EB3E-43DE-988B-53B029C3E4AF}"/>
                </a:ext>
              </a:extLst>
            </p:cNvPr>
            <p:cNvSpPr txBox="1"/>
            <p:nvPr/>
          </p:nvSpPr>
          <p:spPr>
            <a:xfrm>
              <a:off x="7550339" y="3429000"/>
              <a:ext cx="2657476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/>
                <a:t>QRS/LVEDV  &lt;0.67</a:t>
              </a:r>
            </a:p>
            <a:p>
              <a:r>
                <a:rPr lang="en-US" altLang="ja-JP" dirty="0"/>
                <a:t>QRS/LVEDV</a:t>
              </a:r>
              <a:r>
                <a:rPr lang="ja-JP" altLang="en-US" dirty="0"/>
                <a:t>  ≥</a:t>
              </a:r>
              <a:r>
                <a:rPr lang="en-US" altLang="ja-JP" dirty="0"/>
                <a:t>0.67</a:t>
              </a:r>
              <a:endParaRPr kumimoji="1" lang="ja-JP" altLang="en-US" dirty="0"/>
            </a:p>
          </p:txBody>
        </p: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3964651E-EE7B-4161-BEC5-002E6D777E3C}"/>
                </a:ext>
              </a:extLst>
            </p:cNvPr>
            <p:cNvCxnSpPr>
              <a:cxnSpLocks/>
            </p:cNvCxnSpPr>
            <p:nvPr/>
          </p:nvCxnSpPr>
          <p:spPr>
            <a:xfrm>
              <a:off x="7195808" y="3613666"/>
              <a:ext cx="354531" cy="0"/>
            </a:xfrm>
            <a:prstGeom prst="line">
              <a:avLst/>
            </a:prstGeom>
            <a:ln w="28575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ECFBE791-D56C-40AC-B278-EF636FA979C8}"/>
                </a:ext>
              </a:extLst>
            </p:cNvPr>
            <p:cNvCxnSpPr>
              <a:cxnSpLocks/>
            </p:cNvCxnSpPr>
            <p:nvPr/>
          </p:nvCxnSpPr>
          <p:spPr>
            <a:xfrm>
              <a:off x="7195808" y="3896695"/>
              <a:ext cx="354531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17C71EB-FA51-4764-816C-DA855D88DA9E}"/>
              </a:ext>
            </a:extLst>
          </p:cNvPr>
          <p:cNvSpPr txBox="1"/>
          <p:nvPr/>
        </p:nvSpPr>
        <p:spPr>
          <a:xfrm>
            <a:off x="776573" y="306943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6144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92</TotalTime>
  <Words>179</Words>
  <Application>Microsoft Office PowerPoint</Application>
  <PresentationFormat>ワイド画面</PresentationFormat>
  <Paragraphs>72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SUKE KONDO</dc:creator>
  <cp:lastModifiedBy>KONDO YUSUKE</cp:lastModifiedBy>
  <cp:revision>53</cp:revision>
  <cp:lastPrinted>2020-12-09T07:46:23Z</cp:lastPrinted>
  <dcterms:created xsi:type="dcterms:W3CDTF">2020-12-03T02:50:18Z</dcterms:created>
  <dcterms:modified xsi:type="dcterms:W3CDTF">2024-03-07T21:32:12Z</dcterms:modified>
</cp:coreProperties>
</file>